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9"/>
  </p:notesMasterIdLst>
  <p:sldIdLst>
    <p:sldId id="352" r:id="rId2"/>
    <p:sldId id="828" r:id="rId3"/>
    <p:sldId id="906" r:id="rId4"/>
    <p:sldId id="907" r:id="rId5"/>
    <p:sldId id="874" r:id="rId6"/>
    <p:sldId id="903" r:id="rId7"/>
    <p:sldId id="904" r:id="rId8"/>
    <p:sldId id="890" r:id="rId9"/>
    <p:sldId id="897" r:id="rId10"/>
    <p:sldId id="898" r:id="rId11"/>
    <p:sldId id="899" r:id="rId12"/>
    <p:sldId id="908" r:id="rId13"/>
    <p:sldId id="900" r:id="rId14"/>
    <p:sldId id="909" r:id="rId15"/>
    <p:sldId id="902" r:id="rId16"/>
    <p:sldId id="868" r:id="rId17"/>
    <p:sldId id="896" r:id="rId1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  <p15:guide id="3" orient="horz" pos="1704" userDrawn="1">
          <p15:clr>
            <a:srgbClr val="A4A3A4"/>
          </p15:clr>
        </p15:guide>
        <p15:guide id="4" orient="horz" pos="1248" userDrawn="1">
          <p15:clr>
            <a:srgbClr val="A4A3A4"/>
          </p15:clr>
        </p15:guide>
        <p15:guide id="5" orient="horz" pos="2616" userDrawn="1">
          <p15:clr>
            <a:srgbClr val="A4A3A4"/>
          </p15:clr>
        </p15:guide>
        <p15:guide id="6" orient="horz" pos="3048" userDrawn="1">
          <p15:clr>
            <a:srgbClr val="A4A3A4"/>
          </p15:clr>
        </p15:guide>
        <p15:guide id="7" orient="horz" pos="3264" userDrawn="1">
          <p15:clr>
            <a:srgbClr val="A4A3A4"/>
          </p15:clr>
        </p15:guide>
        <p15:guide id="8" orient="horz" pos="3504" userDrawn="1">
          <p15:clr>
            <a:srgbClr val="A4A3A4"/>
          </p15:clr>
        </p15:guide>
        <p15:guide id="9" pos="50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2AED0"/>
    <a:srgbClr val="929292"/>
    <a:srgbClr val="941651"/>
    <a:srgbClr val="FF2600"/>
    <a:srgbClr val="929000"/>
    <a:srgbClr val="4CABC3"/>
    <a:srgbClr val="4C86C3"/>
    <a:srgbClr val="5599E0"/>
    <a:srgbClr val="76B2FF"/>
    <a:srgbClr val="76D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334"/>
    <p:restoredTop sz="96197"/>
  </p:normalViewPr>
  <p:slideViewPr>
    <p:cSldViewPr snapToGrid="0">
      <p:cViewPr varScale="1">
        <p:scale>
          <a:sx n="119" d="100"/>
          <a:sy n="119" d="100"/>
        </p:scale>
        <p:origin x="408" y="192"/>
      </p:cViewPr>
      <p:guideLst>
        <p:guide orient="horz" pos="2160"/>
        <p:guide pos="3840"/>
        <p:guide orient="horz" pos="1704"/>
        <p:guide orient="horz" pos="1248"/>
        <p:guide orient="horz" pos="2616"/>
        <p:guide orient="horz" pos="3048"/>
        <p:guide orient="horz" pos="3264"/>
        <p:guide orient="horz" pos="3504"/>
        <p:guide pos="50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8DFBEDB-6AC3-374B-A6EB-3F5B6C224B34}" type="datetimeFigureOut">
              <a:rPr lang="en-US" smtClean="0"/>
              <a:t>12/18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13547F-192E-E74F-A1DF-5DD9C6AFA0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75763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5112351-11D4-0043-AA8C-C79F40AAD2A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8615561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5112351-11D4-0043-AA8C-C79F40AAD2A3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1803437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5112351-11D4-0043-AA8C-C79F40AAD2A3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0300797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5112351-11D4-0043-AA8C-C79F40AAD2A3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3170407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5112351-11D4-0043-AA8C-C79F40AAD2A3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238001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5112351-11D4-0043-AA8C-C79F40AAD2A3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6426892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5112351-11D4-0043-AA8C-C79F40AAD2A3}" type="slidenum">
              <a:rPr lang="en-US" smtClean="0"/>
              <a:t>1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036279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5112351-11D4-0043-AA8C-C79F40AAD2A3}" type="slidenum">
              <a:rPr lang="en-US" smtClean="0"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6026520"/>
      </p:ext>
    </p:extLst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5112351-11D4-0043-AA8C-C79F40AAD2A3}" type="slidenum">
              <a:rPr lang="en-US" smtClean="0"/>
              <a:t>1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582485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5112351-11D4-0043-AA8C-C79F40AAD2A3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680958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5112351-11D4-0043-AA8C-C79F40AAD2A3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734089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5112351-11D4-0043-AA8C-C79F40AAD2A3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1573484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5112351-11D4-0043-AA8C-C79F40AAD2A3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5853880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5112351-11D4-0043-AA8C-C79F40AAD2A3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1604037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5112351-11D4-0043-AA8C-C79F40AAD2A3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3499574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5112351-11D4-0043-AA8C-C79F40AAD2A3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7105249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5112351-11D4-0043-AA8C-C79F40AAD2A3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10386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FB225F-FCD2-C73B-3A2A-29D7DBDCBDE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BB96CDA-54BE-FE89-E57A-A7A3881BD0E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861B6F-E80B-004D-0C2B-A60FB74B46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EA4A91-5C83-0A45-AD85-69BAC22ABB5C}" type="datetimeFigureOut">
              <a:rPr lang="en-US" smtClean="0"/>
              <a:t>12/18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D8EBE2-F61F-9D08-A322-2B33ABCD2E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9A3E89-B07F-6A34-8E8D-13B1DC3599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A67B1-B3C3-8342-958D-1AFC2FE537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54164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20B924-2392-C49C-DB85-1B3B44F612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535AE4A-253A-E4F5-27B5-B8B194FE95B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13206E-D0D1-5FDE-B23A-1AB29EB3EB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EA4A91-5C83-0A45-AD85-69BAC22ABB5C}" type="datetimeFigureOut">
              <a:rPr lang="en-US" smtClean="0"/>
              <a:t>12/18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75333B-A31E-0E99-2C52-57ABA36EB6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712FE1-A324-B084-B373-9D9506F7D2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A67B1-B3C3-8342-958D-1AFC2FE537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38991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1CDDBB6-4F08-481D-6FA8-57BD306D710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B96A0D2-A298-E6D1-E9D8-56C296E1F32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F508BD-D026-8018-EB25-C1C34E029B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EA4A91-5C83-0A45-AD85-69BAC22ABB5C}" type="datetimeFigureOut">
              <a:rPr lang="en-US" smtClean="0"/>
              <a:t>12/18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C185FD-296C-CF42-9B37-4918EF4A22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D6B847-4A1A-1C07-7364-8BA7EC64F3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A67B1-B3C3-8342-958D-1AFC2FE537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93342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F8206D-1B96-D71D-4253-CE100BAE60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5EC3EB-1499-3EC8-4A32-F75CAB7785C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ED6FD7-2E84-735D-4985-87787BF429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EA4A91-5C83-0A45-AD85-69BAC22ABB5C}" type="datetimeFigureOut">
              <a:rPr lang="en-US" smtClean="0"/>
              <a:t>12/18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19698E-1F51-ED46-8A87-102E5BDB48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06EBC7-F18C-8F7C-40AF-DA4C6E8003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A67B1-B3C3-8342-958D-1AFC2FE537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85725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87D4D9-361C-C7F7-8DCA-DA5553FD9F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33E81A3-AC59-6DEF-72E5-39CCFEF896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8A1611-B5C5-A47B-7032-793E8632C9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EA4A91-5C83-0A45-AD85-69BAC22ABB5C}" type="datetimeFigureOut">
              <a:rPr lang="en-US" smtClean="0"/>
              <a:t>12/18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CA936F-1D7C-F3E7-9C5B-1053BDD0C8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BB2DFF-5CEC-939C-5817-7A27D8D9A4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A67B1-B3C3-8342-958D-1AFC2FE537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17414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87D5F3-9D33-4CF5-BC81-C31B89A542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405FE99-7E62-7614-5E1D-FDECA7CEC29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5A8BE47-9FAF-D607-EDE6-B7041278C0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218D629-840C-7BF7-3CBB-F3553BDF6D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EA4A91-5C83-0A45-AD85-69BAC22ABB5C}" type="datetimeFigureOut">
              <a:rPr lang="en-US" smtClean="0"/>
              <a:t>12/18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042E246-9D31-7589-3201-61EEDC1B80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8892DEB-83A3-9FD1-CA6A-7096BE08F9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A67B1-B3C3-8342-958D-1AFC2FE537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80908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52EA8C-FAAD-9CFA-E470-91B97E88A1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6E375AA-22F4-50E2-F6D9-1EBAD73C62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B9EA04C-7F60-FE58-A990-6FBF0C4E013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44DED97-A643-5BD9-4C7D-3C5B2696735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3E73CA4-2B9B-DBDC-9722-4B6614E55D2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0B0E56E-D022-8122-EBF8-C000084889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EA4A91-5C83-0A45-AD85-69BAC22ABB5C}" type="datetimeFigureOut">
              <a:rPr lang="en-US" smtClean="0"/>
              <a:t>12/18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65A0DF4-E24A-8509-215B-52FDEF7FA3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E3212D9-CA13-0201-E5AD-FAE3DB88A6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A67B1-B3C3-8342-958D-1AFC2FE537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55602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5C9EEA-676B-0649-D07A-0EDA0040B3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E6CD547-47F8-A017-434A-4246E4A863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EA4A91-5C83-0A45-AD85-69BAC22ABB5C}" type="datetimeFigureOut">
              <a:rPr lang="en-US" smtClean="0"/>
              <a:t>12/18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4A45743-9CDE-7E8F-D3D7-66A93D1176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289588F-93A1-C616-6B3D-20C77783C7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A67B1-B3C3-8342-958D-1AFC2FE537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32175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0368658-739A-ED4B-D206-C6F660EB3C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EA4A91-5C83-0A45-AD85-69BAC22ABB5C}" type="datetimeFigureOut">
              <a:rPr lang="en-US" smtClean="0"/>
              <a:t>12/18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D5BDB21-9092-F1C8-72D6-623EE5A6BF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06D5C60-C2CF-91BF-30D7-724686BC64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A67B1-B3C3-8342-958D-1AFC2FE537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40891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245A88-D045-4392-83F8-BF09D6B9CE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8ABF5E1-963A-CA2A-CC8E-22037C8BB8A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92C8796-AE37-CF3F-CAB5-2BEB048A11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EC7DAE5-D1D2-C623-AD51-8F305EFC0D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EA4A91-5C83-0A45-AD85-69BAC22ABB5C}" type="datetimeFigureOut">
              <a:rPr lang="en-US" smtClean="0"/>
              <a:t>12/18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92B8148-897E-7A57-B04E-BF3F13926C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6CC0CE6-A64F-A010-2D55-BE0E26225D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A67B1-B3C3-8342-958D-1AFC2FE537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95362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8261E1-CC77-B68F-6849-B24FB346E9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D0D77E2-DBDB-FC48-E9DE-044A4FBA63B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5B2BD55-8AC1-8686-0AE9-85953C2677A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9A76EC8-E1E8-1DA2-3280-ED01499774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EA4A91-5C83-0A45-AD85-69BAC22ABB5C}" type="datetimeFigureOut">
              <a:rPr lang="en-US" smtClean="0"/>
              <a:t>12/18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60E8B86-FC14-09E8-D4B0-EC1CFF165E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F451F7F-5E9E-C940-A98E-06429C51D2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A67B1-B3C3-8342-958D-1AFC2FE537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50498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678ACD6-F76F-FC59-0BA4-835D4746D9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FDF8CBD-3F25-ED55-3F2B-B280515681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F3A4A2-732A-CF7A-B15D-C459CBEC8BC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EA4A91-5C83-0A45-AD85-69BAC22ABB5C}" type="datetimeFigureOut">
              <a:rPr lang="en-US" smtClean="0"/>
              <a:t>12/18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F9F651-7797-21D7-FAAB-9C91E0CC983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D33823-BD57-AE9B-5ACC-DDBB885CE95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BA67B1-B3C3-8342-958D-1AFC2FE537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37236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Relationship Id="rId4" Type="http://schemas.microsoft.com/office/2007/relationships/hdphoto" Target="../media/hdphoto2.wdp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Relationship Id="rId4" Type="http://schemas.microsoft.com/office/2007/relationships/hdphoto" Target="../media/hdphoto1.wdp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26EB805-A0DF-0F4F-9998-3857A3C60B1C}"/>
              </a:ext>
            </a:extLst>
          </p:cNvPr>
          <p:cNvSpPr txBox="1"/>
          <p:nvPr/>
        </p:nvSpPr>
        <p:spPr>
          <a:xfrm>
            <a:off x="0" y="1815155"/>
            <a:ext cx="12192000" cy="11318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algn="ctr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24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mTORC1 Controls Postprandial Hepatic Glycogen Synthesis Via </a:t>
            </a:r>
            <a:r>
              <a:rPr lang="en-US" sz="2400" b="1" i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Ppp1r3b</a:t>
            </a:r>
          </a:p>
          <a:p>
            <a:pPr marL="0" marR="0" algn="ctr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2400" b="1" u="sng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Uncropped full gel images</a:t>
            </a:r>
            <a:endParaRPr lang="en-US" sz="2400" u="sng" dirty="0">
              <a:effectLst/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1552B943-22F7-C246-8EA6-3C0AAB91E46E}"/>
              </a:ext>
            </a:extLst>
          </p:cNvPr>
          <p:cNvSpPr txBox="1"/>
          <p:nvPr/>
        </p:nvSpPr>
        <p:spPr>
          <a:xfrm>
            <a:off x="1884262" y="4282549"/>
            <a:ext cx="8423476" cy="17029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algn="ctr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Kahealani Uehara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1,2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, Won Dong Lee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7,8,10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, Megan Stefkovich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1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,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Dipsikha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Biswas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11,12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, Anna Garcia Whitlock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1,4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, Dominic Santoleri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1,2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, William Quinn III, Talia Coopersmith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1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, Kate Townsend Creasy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1,3,6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, Daniel J. Rader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1,3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, Kei Sakamoto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11,12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, Joshua D. Rabinowitz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7,8,9,10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, Paul M. Titchenell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1,5</a:t>
            </a:r>
            <a:endParaRPr lang="en-US" sz="1800" dirty="0">
              <a:effectLst/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8632584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close-up of a grid&#10;&#10;Description automatically generated">
            <a:extLst>
              <a:ext uri="{FF2B5EF4-FFF2-40B4-BE49-F238E27FC236}">
                <a16:creationId xmlns:a16="http://schemas.microsoft.com/office/drawing/2014/main" id="{FF34A93C-0C91-9687-6C8E-81870D3BB32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113" t="594" r="206" b="2463"/>
          <a:stretch/>
        </p:blipFill>
        <p:spPr>
          <a:xfrm>
            <a:off x="1345426" y="1026908"/>
            <a:ext cx="10241280" cy="4625781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39" name="Group 38">
            <a:extLst>
              <a:ext uri="{FF2B5EF4-FFF2-40B4-BE49-F238E27FC236}">
                <a16:creationId xmlns:a16="http://schemas.microsoft.com/office/drawing/2014/main" id="{26E52161-C3DC-BF96-6AD6-CCCD04FAC12C}"/>
              </a:ext>
            </a:extLst>
          </p:cNvPr>
          <p:cNvGrpSpPr/>
          <p:nvPr/>
        </p:nvGrpSpPr>
        <p:grpSpPr>
          <a:xfrm>
            <a:off x="2319509" y="-55326"/>
            <a:ext cx="3612995" cy="370841"/>
            <a:chOff x="2105314" y="853068"/>
            <a:chExt cx="3612995" cy="370841"/>
          </a:xfrm>
        </p:grpSpPr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0D92A6C5-A7EF-F766-4BF4-85DE7F1A67E6}"/>
                </a:ext>
              </a:extLst>
            </p:cNvPr>
            <p:cNvCxnSpPr/>
            <p:nvPr/>
          </p:nvCxnSpPr>
          <p:spPr>
            <a:xfrm>
              <a:off x="2105314" y="1223909"/>
              <a:ext cx="361299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9E76A1CE-876B-FFF4-0A6A-8A23631FBA2D}"/>
                </a:ext>
              </a:extLst>
            </p:cNvPr>
            <p:cNvSpPr txBox="1"/>
            <p:nvPr/>
          </p:nvSpPr>
          <p:spPr>
            <a:xfrm>
              <a:off x="2105314" y="853068"/>
              <a:ext cx="36129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Fasted</a:t>
              </a:r>
            </a:p>
          </p:txBody>
        </p:sp>
      </p:grpSp>
      <p:grpSp>
        <p:nvGrpSpPr>
          <p:cNvPr id="22" name="Group 21">
            <a:extLst>
              <a:ext uri="{FF2B5EF4-FFF2-40B4-BE49-F238E27FC236}">
                <a16:creationId xmlns:a16="http://schemas.microsoft.com/office/drawing/2014/main" id="{C8154DDE-6C94-B1C7-B0FE-8BF5097C0469}"/>
              </a:ext>
            </a:extLst>
          </p:cNvPr>
          <p:cNvGrpSpPr/>
          <p:nvPr/>
        </p:nvGrpSpPr>
        <p:grpSpPr>
          <a:xfrm>
            <a:off x="6917744" y="-53817"/>
            <a:ext cx="3612994" cy="369332"/>
            <a:chOff x="6592727" y="1885435"/>
            <a:chExt cx="3646100" cy="369332"/>
          </a:xfrm>
        </p:grpSpPr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0BB49961-E24D-BCAF-B673-428585BE77FE}"/>
                </a:ext>
              </a:extLst>
            </p:cNvPr>
            <p:cNvCxnSpPr>
              <a:cxnSpLocks/>
            </p:cNvCxnSpPr>
            <p:nvPr/>
          </p:nvCxnSpPr>
          <p:spPr>
            <a:xfrm>
              <a:off x="6592727" y="2253258"/>
              <a:ext cx="361299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F0486AE8-A58B-8CC0-1EC5-8E96FA4DB46E}"/>
                </a:ext>
              </a:extLst>
            </p:cNvPr>
            <p:cNvSpPr txBox="1"/>
            <p:nvPr/>
          </p:nvSpPr>
          <p:spPr>
            <a:xfrm>
              <a:off x="6625833" y="1885435"/>
              <a:ext cx="36129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Refed</a:t>
              </a:r>
            </a:p>
          </p:txBody>
        </p:sp>
      </p:grpSp>
      <p:grpSp>
        <p:nvGrpSpPr>
          <p:cNvPr id="59" name="Group 58">
            <a:extLst>
              <a:ext uri="{FF2B5EF4-FFF2-40B4-BE49-F238E27FC236}">
                <a16:creationId xmlns:a16="http://schemas.microsoft.com/office/drawing/2014/main" id="{D4426270-B8D8-45D6-8EBB-4463B9AE23DD}"/>
              </a:ext>
            </a:extLst>
          </p:cNvPr>
          <p:cNvGrpSpPr/>
          <p:nvPr/>
        </p:nvGrpSpPr>
        <p:grpSpPr>
          <a:xfrm>
            <a:off x="8945918" y="301880"/>
            <a:ext cx="1880761" cy="369332"/>
            <a:chOff x="4259067" y="2088861"/>
            <a:chExt cx="1661336" cy="369332"/>
          </a:xfrm>
        </p:grpSpPr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99329D17-994D-F884-E452-95D92622B260}"/>
                </a:ext>
              </a:extLst>
            </p:cNvPr>
            <p:cNvSpPr txBox="1"/>
            <p:nvPr/>
          </p:nvSpPr>
          <p:spPr>
            <a:xfrm>
              <a:off x="4259067" y="2088861"/>
              <a:ext cx="16613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L-Raptor-KO</a:t>
              </a:r>
            </a:p>
          </p:txBody>
        </p:sp>
        <p:cxnSp>
          <p:nvCxnSpPr>
            <p:cNvPr id="61" name="Straight Connector 60">
              <a:extLst>
                <a:ext uri="{FF2B5EF4-FFF2-40B4-BE49-F238E27FC236}">
                  <a16:creationId xmlns:a16="http://schemas.microsoft.com/office/drawing/2014/main" id="{8A68CAF4-BA67-8119-9AC9-BC90C7189CA2}"/>
                </a:ext>
              </a:extLst>
            </p:cNvPr>
            <p:cNvCxnSpPr>
              <a:cxnSpLocks/>
            </p:cNvCxnSpPr>
            <p:nvPr/>
          </p:nvCxnSpPr>
          <p:spPr>
            <a:xfrm>
              <a:off x="4259067" y="2458193"/>
              <a:ext cx="16613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07E0DFBD-4120-9239-5910-60ABF9AA6F83}"/>
              </a:ext>
            </a:extLst>
          </p:cNvPr>
          <p:cNvGrpSpPr/>
          <p:nvPr/>
        </p:nvGrpSpPr>
        <p:grpSpPr>
          <a:xfrm>
            <a:off x="6682984" y="301880"/>
            <a:ext cx="1880761" cy="369332"/>
            <a:chOff x="4259067" y="2088861"/>
            <a:chExt cx="1661336" cy="369332"/>
          </a:xfrm>
        </p:grpSpPr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A2C9EBAC-F98A-CC03-2757-E5137C6DBFAF}"/>
                </a:ext>
              </a:extLst>
            </p:cNvPr>
            <p:cNvSpPr txBox="1"/>
            <p:nvPr/>
          </p:nvSpPr>
          <p:spPr>
            <a:xfrm>
              <a:off x="4259067" y="2088861"/>
              <a:ext cx="16613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31D585D7-359E-F740-7F4E-9619588B481D}"/>
                </a:ext>
              </a:extLst>
            </p:cNvPr>
            <p:cNvCxnSpPr>
              <a:cxnSpLocks/>
            </p:cNvCxnSpPr>
            <p:nvPr/>
          </p:nvCxnSpPr>
          <p:spPr>
            <a:xfrm>
              <a:off x="4259067" y="2458193"/>
              <a:ext cx="16613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D0AFA08F-802F-1A09-8A39-53023500505A}"/>
              </a:ext>
            </a:extLst>
          </p:cNvPr>
          <p:cNvGrpSpPr/>
          <p:nvPr/>
        </p:nvGrpSpPr>
        <p:grpSpPr>
          <a:xfrm>
            <a:off x="4203593" y="306990"/>
            <a:ext cx="2011680" cy="369332"/>
            <a:chOff x="4259067" y="2088861"/>
            <a:chExt cx="1661336" cy="369332"/>
          </a:xfrm>
        </p:grpSpPr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EF0DADD5-0075-99F5-5C7A-CA046CD7D3FC}"/>
                </a:ext>
              </a:extLst>
            </p:cNvPr>
            <p:cNvSpPr txBox="1"/>
            <p:nvPr/>
          </p:nvSpPr>
          <p:spPr>
            <a:xfrm>
              <a:off x="4259067" y="2088861"/>
              <a:ext cx="16613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L-Raptor-KO</a:t>
              </a:r>
            </a:p>
          </p:txBody>
        </p: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1C91D279-92D7-2AA5-135C-4F97F0FD7F72}"/>
                </a:ext>
              </a:extLst>
            </p:cNvPr>
            <p:cNvCxnSpPr>
              <a:cxnSpLocks/>
            </p:cNvCxnSpPr>
            <p:nvPr/>
          </p:nvCxnSpPr>
          <p:spPr>
            <a:xfrm>
              <a:off x="4259067" y="2458193"/>
              <a:ext cx="16613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" name="Group 17">
            <a:extLst>
              <a:ext uri="{FF2B5EF4-FFF2-40B4-BE49-F238E27FC236}">
                <a16:creationId xmlns:a16="http://schemas.microsoft.com/office/drawing/2014/main" id="{4B038CB6-8EC8-E154-6B41-ADBF45A29F70}"/>
              </a:ext>
            </a:extLst>
          </p:cNvPr>
          <p:cNvGrpSpPr/>
          <p:nvPr/>
        </p:nvGrpSpPr>
        <p:grpSpPr>
          <a:xfrm>
            <a:off x="2027813" y="301880"/>
            <a:ext cx="2012691" cy="369332"/>
            <a:chOff x="4259067" y="2088861"/>
            <a:chExt cx="1661336" cy="369332"/>
          </a:xfrm>
        </p:grpSpPr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87FE6A94-630C-FE23-741A-AE1454E85780}"/>
                </a:ext>
              </a:extLst>
            </p:cNvPr>
            <p:cNvSpPr txBox="1"/>
            <p:nvPr/>
          </p:nvSpPr>
          <p:spPr>
            <a:xfrm>
              <a:off x="4259067" y="2088861"/>
              <a:ext cx="16613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E9C0FE81-F752-BF54-038F-B5FDEA75752E}"/>
                </a:ext>
              </a:extLst>
            </p:cNvPr>
            <p:cNvCxnSpPr>
              <a:cxnSpLocks/>
            </p:cNvCxnSpPr>
            <p:nvPr/>
          </p:nvCxnSpPr>
          <p:spPr>
            <a:xfrm>
              <a:off x="4259067" y="2458193"/>
              <a:ext cx="16613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4" name="TextBox 33">
            <a:extLst>
              <a:ext uri="{FF2B5EF4-FFF2-40B4-BE49-F238E27FC236}">
                <a16:creationId xmlns:a16="http://schemas.microsoft.com/office/drawing/2014/main" id="{141A44A0-1028-43A0-31AF-508A0365573B}"/>
              </a:ext>
            </a:extLst>
          </p:cNvPr>
          <p:cNvSpPr txBox="1"/>
          <p:nvPr/>
        </p:nvSpPr>
        <p:spPr>
          <a:xfrm>
            <a:off x="335352" y="3252402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HSP9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7E7CA19-2168-CABB-6423-3CA08DB8439F}"/>
              </a:ext>
            </a:extLst>
          </p:cNvPr>
          <p:cNvSpPr txBox="1"/>
          <p:nvPr/>
        </p:nvSpPr>
        <p:spPr>
          <a:xfrm>
            <a:off x="10994236" y="648866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3A</a:t>
            </a:r>
          </a:p>
        </p:txBody>
      </p:sp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F828E4AF-7D14-97C9-ABC7-809F21837476}"/>
              </a:ext>
            </a:extLst>
          </p:cNvPr>
          <p:cNvCxnSpPr>
            <a:cxnSpLocks/>
          </p:cNvCxnSpPr>
          <p:nvPr/>
        </p:nvCxnSpPr>
        <p:spPr>
          <a:xfrm>
            <a:off x="1169718" y="3437068"/>
            <a:ext cx="645344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Rectangle 4">
            <a:extLst>
              <a:ext uri="{FF2B5EF4-FFF2-40B4-BE49-F238E27FC236}">
                <a16:creationId xmlns:a16="http://schemas.microsoft.com/office/drawing/2014/main" id="{6E6F2ED7-1F03-D72A-58DD-3068B400ABA1}"/>
              </a:ext>
            </a:extLst>
          </p:cNvPr>
          <p:cNvSpPr/>
          <p:nvPr/>
        </p:nvSpPr>
        <p:spPr>
          <a:xfrm>
            <a:off x="1909500" y="2862429"/>
            <a:ext cx="9112781" cy="759296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844376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A close-up of a black and white photo&#10;&#10;Description automatically generated">
            <a:extLst>
              <a:ext uri="{FF2B5EF4-FFF2-40B4-BE49-F238E27FC236}">
                <a16:creationId xmlns:a16="http://schemas.microsoft.com/office/drawing/2014/main" id="{FF5FEA88-80EE-52B4-5E20-BF163276F0C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7300" t="22812" r="5040" b="1552"/>
          <a:stretch/>
        </p:blipFill>
        <p:spPr>
          <a:xfrm>
            <a:off x="1105989" y="1153252"/>
            <a:ext cx="10763793" cy="5079646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39" name="Group 38">
            <a:extLst>
              <a:ext uri="{FF2B5EF4-FFF2-40B4-BE49-F238E27FC236}">
                <a16:creationId xmlns:a16="http://schemas.microsoft.com/office/drawing/2014/main" id="{26E52161-C3DC-BF96-6AD6-CCCD04FAC12C}"/>
              </a:ext>
            </a:extLst>
          </p:cNvPr>
          <p:cNvGrpSpPr/>
          <p:nvPr/>
        </p:nvGrpSpPr>
        <p:grpSpPr>
          <a:xfrm>
            <a:off x="2448416" y="-5702"/>
            <a:ext cx="1383751" cy="370841"/>
            <a:chOff x="2105314" y="853068"/>
            <a:chExt cx="3612995" cy="370841"/>
          </a:xfrm>
        </p:grpSpPr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0D92A6C5-A7EF-F766-4BF4-85DE7F1A67E6}"/>
                </a:ext>
              </a:extLst>
            </p:cNvPr>
            <p:cNvCxnSpPr/>
            <p:nvPr/>
          </p:nvCxnSpPr>
          <p:spPr>
            <a:xfrm>
              <a:off x="2105314" y="1223909"/>
              <a:ext cx="361299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9E76A1CE-876B-FFF4-0A6A-8A23631FBA2D}"/>
                </a:ext>
              </a:extLst>
            </p:cNvPr>
            <p:cNvSpPr txBox="1"/>
            <p:nvPr/>
          </p:nvSpPr>
          <p:spPr>
            <a:xfrm>
              <a:off x="2105314" y="853068"/>
              <a:ext cx="36129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Fasted</a:t>
              </a:r>
            </a:p>
          </p:txBody>
        </p:sp>
      </p:grpSp>
      <p:grpSp>
        <p:nvGrpSpPr>
          <p:cNvPr id="22" name="Group 21">
            <a:extLst>
              <a:ext uri="{FF2B5EF4-FFF2-40B4-BE49-F238E27FC236}">
                <a16:creationId xmlns:a16="http://schemas.microsoft.com/office/drawing/2014/main" id="{C8154DDE-6C94-B1C7-B0FE-8BF5097C0469}"/>
              </a:ext>
            </a:extLst>
          </p:cNvPr>
          <p:cNvGrpSpPr/>
          <p:nvPr/>
        </p:nvGrpSpPr>
        <p:grpSpPr>
          <a:xfrm>
            <a:off x="4355502" y="-4947"/>
            <a:ext cx="6598215" cy="369332"/>
            <a:chOff x="6592727" y="1885435"/>
            <a:chExt cx="3646100" cy="369332"/>
          </a:xfrm>
        </p:grpSpPr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0BB49961-E24D-BCAF-B673-428585BE77FE}"/>
                </a:ext>
              </a:extLst>
            </p:cNvPr>
            <p:cNvCxnSpPr>
              <a:cxnSpLocks/>
            </p:cNvCxnSpPr>
            <p:nvPr/>
          </p:nvCxnSpPr>
          <p:spPr>
            <a:xfrm>
              <a:off x="6592727" y="2253258"/>
              <a:ext cx="361299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F0486AE8-A58B-8CC0-1EC5-8E96FA4DB46E}"/>
                </a:ext>
              </a:extLst>
            </p:cNvPr>
            <p:cNvSpPr txBox="1"/>
            <p:nvPr/>
          </p:nvSpPr>
          <p:spPr>
            <a:xfrm>
              <a:off x="6625833" y="1885435"/>
              <a:ext cx="36129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Refed</a:t>
              </a:r>
            </a:p>
          </p:txBody>
        </p:sp>
      </p:grpSp>
      <p:grpSp>
        <p:nvGrpSpPr>
          <p:cNvPr id="59" name="Group 58">
            <a:extLst>
              <a:ext uri="{FF2B5EF4-FFF2-40B4-BE49-F238E27FC236}">
                <a16:creationId xmlns:a16="http://schemas.microsoft.com/office/drawing/2014/main" id="{D4426270-B8D8-45D6-8EBB-4463B9AE23DD}"/>
              </a:ext>
            </a:extLst>
          </p:cNvPr>
          <p:cNvGrpSpPr/>
          <p:nvPr/>
        </p:nvGrpSpPr>
        <p:grpSpPr>
          <a:xfrm>
            <a:off x="8982556" y="395575"/>
            <a:ext cx="2011680" cy="646331"/>
            <a:chOff x="4259067" y="1880514"/>
            <a:chExt cx="1661336" cy="646331"/>
          </a:xfrm>
        </p:grpSpPr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99329D17-994D-F884-E452-95D92622B260}"/>
                </a:ext>
              </a:extLst>
            </p:cNvPr>
            <p:cNvSpPr txBox="1"/>
            <p:nvPr/>
          </p:nvSpPr>
          <p:spPr>
            <a:xfrm>
              <a:off x="4259067" y="1880514"/>
              <a:ext cx="166133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L-Raptor-KO </a:t>
              </a:r>
            </a:p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+ PPP1R3B</a:t>
              </a:r>
            </a:p>
          </p:txBody>
        </p:sp>
        <p:cxnSp>
          <p:nvCxnSpPr>
            <p:cNvPr id="61" name="Straight Connector 60">
              <a:extLst>
                <a:ext uri="{FF2B5EF4-FFF2-40B4-BE49-F238E27FC236}">
                  <a16:creationId xmlns:a16="http://schemas.microsoft.com/office/drawing/2014/main" id="{8A68CAF4-BA67-8119-9AC9-BC90C7189CA2}"/>
                </a:ext>
              </a:extLst>
            </p:cNvPr>
            <p:cNvCxnSpPr>
              <a:cxnSpLocks/>
            </p:cNvCxnSpPr>
            <p:nvPr/>
          </p:nvCxnSpPr>
          <p:spPr>
            <a:xfrm>
              <a:off x="4259067" y="2481639"/>
              <a:ext cx="16613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07E0DFBD-4120-9239-5910-60ABF9AA6F83}"/>
              </a:ext>
            </a:extLst>
          </p:cNvPr>
          <p:cNvGrpSpPr/>
          <p:nvPr/>
        </p:nvGrpSpPr>
        <p:grpSpPr>
          <a:xfrm>
            <a:off x="4174436" y="631983"/>
            <a:ext cx="2012691" cy="369332"/>
            <a:chOff x="4259067" y="2088861"/>
            <a:chExt cx="1661336" cy="369332"/>
          </a:xfrm>
        </p:grpSpPr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A2C9EBAC-F98A-CC03-2757-E5137C6DBFAF}"/>
                </a:ext>
              </a:extLst>
            </p:cNvPr>
            <p:cNvSpPr txBox="1"/>
            <p:nvPr/>
          </p:nvSpPr>
          <p:spPr>
            <a:xfrm>
              <a:off x="4259067" y="2088861"/>
              <a:ext cx="16613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31D585D7-359E-F740-7F4E-9619588B481D}"/>
                </a:ext>
              </a:extLst>
            </p:cNvPr>
            <p:cNvCxnSpPr>
              <a:cxnSpLocks/>
            </p:cNvCxnSpPr>
            <p:nvPr/>
          </p:nvCxnSpPr>
          <p:spPr>
            <a:xfrm>
              <a:off x="4259067" y="2458193"/>
              <a:ext cx="16613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D0AFA08F-802F-1A09-8A39-53023500505A}"/>
              </a:ext>
            </a:extLst>
          </p:cNvPr>
          <p:cNvGrpSpPr/>
          <p:nvPr/>
        </p:nvGrpSpPr>
        <p:grpSpPr>
          <a:xfrm>
            <a:off x="6574151" y="631983"/>
            <a:ext cx="2011680" cy="369332"/>
            <a:chOff x="4259067" y="2088861"/>
            <a:chExt cx="1661336" cy="369332"/>
          </a:xfrm>
        </p:grpSpPr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EF0DADD5-0075-99F5-5C7A-CA046CD7D3FC}"/>
                </a:ext>
              </a:extLst>
            </p:cNvPr>
            <p:cNvSpPr txBox="1"/>
            <p:nvPr/>
          </p:nvSpPr>
          <p:spPr>
            <a:xfrm>
              <a:off x="4259067" y="2088861"/>
              <a:ext cx="16613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L-Raptor-KO</a:t>
              </a:r>
            </a:p>
          </p:txBody>
        </p: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1C91D279-92D7-2AA5-135C-4F97F0FD7F72}"/>
                </a:ext>
              </a:extLst>
            </p:cNvPr>
            <p:cNvCxnSpPr>
              <a:cxnSpLocks/>
            </p:cNvCxnSpPr>
            <p:nvPr/>
          </p:nvCxnSpPr>
          <p:spPr>
            <a:xfrm>
              <a:off x="4259067" y="2458193"/>
              <a:ext cx="16613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" name="Group 17">
            <a:extLst>
              <a:ext uri="{FF2B5EF4-FFF2-40B4-BE49-F238E27FC236}">
                <a16:creationId xmlns:a16="http://schemas.microsoft.com/office/drawing/2014/main" id="{4B038CB6-8EC8-E154-6B41-ADBF45A29F70}"/>
              </a:ext>
            </a:extLst>
          </p:cNvPr>
          <p:cNvGrpSpPr/>
          <p:nvPr/>
        </p:nvGrpSpPr>
        <p:grpSpPr>
          <a:xfrm>
            <a:off x="2448416" y="631983"/>
            <a:ext cx="1383751" cy="369332"/>
            <a:chOff x="4259067" y="2088861"/>
            <a:chExt cx="1661336" cy="369332"/>
          </a:xfrm>
        </p:grpSpPr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87FE6A94-630C-FE23-741A-AE1454E85780}"/>
                </a:ext>
              </a:extLst>
            </p:cNvPr>
            <p:cNvSpPr txBox="1"/>
            <p:nvPr/>
          </p:nvSpPr>
          <p:spPr>
            <a:xfrm>
              <a:off x="4259067" y="2088861"/>
              <a:ext cx="16613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E9C0FE81-F752-BF54-038F-B5FDEA75752E}"/>
                </a:ext>
              </a:extLst>
            </p:cNvPr>
            <p:cNvCxnSpPr>
              <a:cxnSpLocks/>
            </p:cNvCxnSpPr>
            <p:nvPr/>
          </p:nvCxnSpPr>
          <p:spPr>
            <a:xfrm>
              <a:off x="4259067" y="2458193"/>
              <a:ext cx="16613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4" name="TextBox 43">
            <a:extLst>
              <a:ext uri="{FF2B5EF4-FFF2-40B4-BE49-F238E27FC236}">
                <a16:creationId xmlns:a16="http://schemas.microsoft.com/office/drawing/2014/main" id="{B32E393A-C212-6015-51F6-513210570149}"/>
              </a:ext>
            </a:extLst>
          </p:cNvPr>
          <p:cNvSpPr txBox="1"/>
          <p:nvPr/>
        </p:nvSpPr>
        <p:spPr>
          <a:xfrm>
            <a:off x="145945" y="3054532"/>
            <a:ext cx="723275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p-GS</a:t>
            </a:r>
          </a:p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S641)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0589C14-A290-A2B0-0530-878E484B52F8}"/>
              </a:ext>
            </a:extLst>
          </p:cNvPr>
          <p:cNvSpPr txBox="1"/>
          <p:nvPr/>
        </p:nvSpPr>
        <p:spPr>
          <a:xfrm>
            <a:off x="10994236" y="6488668"/>
            <a:ext cx="1197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4C</a:t>
            </a:r>
          </a:p>
        </p:txBody>
      </p: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8DA857FD-B176-E93C-672A-A09235F4B4E9}"/>
              </a:ext>
            </a:extLst>
          </p:cNvPr>
          <p:cNvCxnSpPr>
            <a:cxnSpLocks/>
          </p:cNvCxnSpPr>
          <p:nvPr/>
        </p:nvCxnSpPr>
        <p:spPr>
          <a:xfrm>
            <a:off x="869220" y="3178907"/>
            <a:ext cx="930477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Rectangle 22">
            <a:extLst>
              <a:ext uri="{FF2B5EF4-FFF2-40B4-BE49-F238E27FC236}">
                <a16:creationId xmlns:a16="http://schemas.microsoft.com/office/drawing/2014/main" id="{4544689F-909C-2EDC-10E4-340E8DDE119A}"/>
              </a:ext>
            </a:extLst>
          </p:cNvPr>
          <p:cNvSpPr/>
          <p:nvPr/>
        </p:nvSpPr>
        <p:spPr>
          <a:xfrm>
            <a:off x="2259874" y="2704011"/>
            <a:ext cx="8974183" cy="129322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94018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black and white photo of a grid&#10;&#10;Description automatically generated">
            <a:extLst>
              <a:ext uri="{FF2B5EF4-FFF2-40B4-BE49-F238E27FC236}">
                <a16:creationId xmlns:a16="http://schemas.microsoft.com/office/drawing/2014/main" id="{513314A7-65BF-C401-476F-574C0788F0A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423" t="1170" r="527" b="8112"/>
          <a:stretch/>
        </p:blipFill>
        <p:spPr>
          <a:xfrm>
            <a:off x="1268329" y="1073096"/>
            <a:ext cx="9655342" cy="5464391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39" name="Group 38">
            <a:extLst>
              <a:ext uri="{FF2B5EF4-FFF2-40B4-BE49-F238E27FC236}">
                <a16:creationId xmlns:a16="http://schemas.microsoft.com/office/drawing/2014/main" id="{26E52161-C3DC-BF96-6AD6-CCCD04FAC12C}"/>
              </a:ext>
            </a:extLst>
          </p:cNvPr>
          <p:cNvGrpSpPr/>
          <p:nvPr/>
        </p:nvGrpSpPr>
        <p:grpSpPr>
          <a:xfrm>
            <a:off x="2448416" y="-5702"/>
            <a:ext cx="1383751" cy="370841"/>
            <a:chOff x="2105314" y="853068"/>
            <a:chExt cx="3612995" cy="370841"/>
          </a:xfrm>
        </p:grpSpPr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0D92A6C5-A7EF-F766-4BF4-85DE7F1A67E6}"/>
                </a:ext>
              </a:extLst>
            </p:cNvPr>
            <p:cNvCxnSpPr/>
            <p:nvPr/>
          </p:nvCxnSpPr>
          <p:spPr>
            <a:xfrm>
              <a:off x="2105314" y="1223909"/>
              <a:ext cx="361299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9E76A1CE-876B-FFF4-0A6A-8A23631FBA2D}"/>
                </a:ext>
              </a:extLst>
            </p:cNvPr>
            <p:cNvSpPr txBox="1"/>
            <p:nvPr/>
          </p:nvSpPr>
          <p:spPr>
            <a:xfrm>
              <a:off x="2105314" y="853068"/>
              <a:ext cx="36129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Fasted</a:t>
              </a:r>
            </a:p>
          </p:txBody>
        </p:sp>
      </p:grpSp>
      <p:grpSp>
        <p:nvGrpSpPr>
          <p:cNvPr id="22" name="Group 21">
            <a:extLst>
              <a:ext uri="{FF2B5EF4-FFF2-40B4-BE49-F238E27FC236}">
                <a16:creationId xmlns:a16="http://schemas.microsoft.com/office/drawing/2014/main" id="{C8154DDE-6C94-B1C7-B0FE-8BF5097C0469}"/>
              </a:ext>
            </a:extLst>
          </p:cNvPr>
          <p:cNvGrpSpPr/>
          <p:nvPr/>
        </p:nvGrpSpPr>
        <p:grpSpPr>
          <a:xfrm>
            <a:off x="4355502" y="-4947"/>
            <a:ext cx="6598215" cy="369332"/>
            <a:chOff x="6592727" y="1885435"/>
            <a:chExt cx="3646100" cy="369332"/>
          </a:xfrm>
        </p:grpSpPr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0BB49961-E24D-BCAF-B673-428585BE77FE}"/>
                </a:ext>
              </a:extLst>
            </p:cNvPr>
            <p:cNvCxnSpPr>
              <a:cxnSpLocks/>
            </p:cNvCxnSpPr>
            <p:nvPr/>
          </p:nvCxnSpPr>
          <p:spPr>
            <a:xfrm>
              <a:off x="6592727" y="2253258"/>
              <a:ext cx="361299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F0486AE8-A58B-8CC0-1EC5-8E96FA4DB46E}"/>
                </a:ext>
              </a:extLst>
            </p:cNvPr>
            <p:cNvSpPr txBox="1"/>
            <p:nvPr/>
          </p:nvSpPr>
          <p:spPr>
            <a:xfrm>
              <a:off x="6625833" y="1885435"/>
              <a:ext cx="36129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Refed</a:t>
              </a:r>
            </a:p>
          </p:txBody>
        </p:sp>
      </p:grpSp>
      <p:grpSp>
        <p:nvGrpSpPr>
          <p:cNvPr id="59" name="Group 58">
            <a:extLst>
              <a:ext uri="{FF2B5EF4-FFF2-40B4-BE49-F238E27FC236}">
                <a16:creationId xmlns:a16="http://schemas.microsoft.com/office/drawing/2014/main" id="{D4426270-B8D8-45D6-8EBB-4463B9AE23DD}"/>
              </a:ext>
            </a:extLst>
          </p:cNvPr>
          <p:cNvGrpSpPr/>
          <p:nvPr/>
        </p:nvGrpSpPr>
        <p:grpSpPr>
          <a:xfrm>
            <a:off x="8982556" y="395575"/>
            <a:ext cx="2011680" cy="646331"/>
            <a:chOff x="4259067" y="1880514"/>
            <a:chExt cx="1661336" cy="646331"/>
          </a:xfrm>
        </p:grpSpPr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99329D17-994D-F884-E452-95D92622B260}"/>
                </a:ext>
              </a:extLst>
            </p:cNvPr>
            <p:cNvSpPr txBox="1"/>
            <p:nvPr/>
          </p:nvSpPr>
          <p:spPr>
            <a:xfrm>
              <a:off x="4259067" y="1880514"/>
              <a:ext cx="166133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L-Raptor-KO </a:t>
              </a:r>
            </a:p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+ PPP1R3B</a:t>
              </a:r>
            </a:p>
          </p:txBody>
        </p:sp>
        <p:cxnSp>
          <p:nvCxnSpPr>
            <p:cNvPr id="61" name="Straight Connector 60">
              <a:extLst>
                <a:ext uri="{FF2B5EF4-FFF2-40B4-BE49-F238E27FC236}">
                  <a16:creationId xmlns:a16="http://schemas.microsoft.com/office/drawing/2014/main" id="{8A68CAF4-BA67-8119-9AC9-BC90C7189CA2}"/>
                </a:ext>
              </a:extLst>
            </p:cNvPr>
            <p:cNvCxnSpPr>
              <a:cxnSpLocks/>
            </p:cNvCxnSpPr>
            <p:nvPr/>
          </p:nvCxnSpPr>
          <p:spPr>
            <a:xfrm>
              <a:off x="4259067" y="2481639"/>
              <a:ext cx="16613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07E0DFBD-4120-9239-5910-60ABF9AA6F83}"/>
              </a:ext>
            </a:extLst>
          </p:cNvPr>
          <p:cNvGrpSpPr/>
          <p:nvPr/>
        </p:nvGrpSpPr>
        <p:grpSpPr>
          <a:xfrm>
            <a:off x="4174436" y="631983"/>
            <a:ext cx="2012691" cy="369332"/>
            <a:chOff x="4259067" y="2088861"/>
            <a:chExt cx="1661336" cy="369332"/>
          </a:xfrm>
        </p:grpSpPr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A2C9EBAC-F98A-CC03-2757-E5137C6DBFAF}"/>
                </a:ext>
              </a:extLst>
            </p:cNvPr>
            <p:cNvSpPr txBox="1"/>
            <p:nvPr/>
          </p:nvSpPr>
          <p:spPr>
            <a:xfrm>
              <a:off x="4259067" y="2088861"/>
              <a:ext cx="16613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31D585D7-359E-F740-7F4E-9619588B481D}"/>
                </a:ext>
              </a:extLst>
            </p:cNvPr>
            <p:cNvCxnSpPr>
              <a:cxnSpLocks/>
            </p:cNvCxnSpPr>
            <p:nvPr/>
          </p:nvCxnSpPr>
          <p:spPr>
            <a:xfrm>
              <a:off x="4259067" y="2458193"/>
              <a:ext cx="16613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D0AFA08F-802F-1A09-8A39-53023500505A}"/>
              </a:ext>
            </a:extLst>
          </p:cNvPr>
          <p:cNvGrpSpPr/>
          <p:nvPr/>
        </p:nvGrpSpPr>
        <p:grpSpPr>
          <a:xfrm>
            <a:off x="6574151" y="631983"/>
            <a:ext cx="2011680" cy="369332"/>
            <a:chOff x="4259067" y="2088861"/>
            <a:chExt cx="1661336" cy="369332"/>
          </a:xfrm>
        </p:grpSpPr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EF0DADD5-0075-99F5-5C7A-CA046CD7D3FC}"/>
                </a:ext>
              </a:extLst>
            </p:cNvPr>
            <p:cNvSpPr txBox="1"/>
            <p:nvPr/>
          </p:nvSpPr>
          <p:spPr>
            <a:xfrm>
              <a:off x="4259067" y="2088861"/>
              <a:ext cx="16613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L-Raptor-KO</a:t>
              </a:r>
            </a:p>
          </p:txBody>
        </p: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1C91D279-92D7-2AA5-135C-4F97F0FD7F72}"/>
                </a:ext>
              </a:extLst>
            </p:cNvPr>
            <p:cNvCxnSpPr>
              <a:cxnSpLocks/>
            </p:cNvCxnSpPr>
            <p:nvPr/>
          </p:nvCxnSpPr>
          <p:spPr>
            <a:xfrm>
              <a:off x="4259067" y="2458193"/>
              <a:ext cx="16613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" name="Group 17">
            <a:extLst>
              <a:ext uri="{FF2B5EF4-FFF2-40B4-BE49-F238E27FC236}">
                <a16:creationId xmlns:a16="http://schemas.microsoft.com/office/drawing/2014/main" id="{4B038CB6-8EC8-E154-6B41-ADBF45A29F70}"/>
              </a:ext>
            </a:extLst>
          </p:cNvPr>
          <p:cNvGrpSpPr/>
          <p:nvPr/>
        </p:nvGrpSpPr>
        <p:grpSpPr>
          <a:xfrm>
            <a:off x="2448416" y="631983"/>
            <a:ext cx="1383751" cy="369332"/>
            <a:chOff x="4259067" y="2088861"/>
            <a:chExt cx="1661336" cy="369332"/>
          </a:xfrm>
        </p:grpSpPr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87FE6A94-630C-FE23-741A-AE1454E85780}"/>
                </a:ext>
              </a:extLst>
            </p:cNvPr>
            <p:cNvSpPr txBox="1"/>
            <p:nvPr/>
          </p:nvSpPr>
          <p:spPr>
            <a:xfrm>
              <a:off x="4259067" y="2088861"/>
              <a:ext cx="16613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E9C0FE81-F752-BF54-038F-B5FDEA75752E}"/>
                </a:ext>
              </a:extLst>
            </p:cNvPr>
            <p:cNvCxnSpPr>
              <a:cxnSpLocks/>
            </p:cNvCxnSpPr>
            <p:nvPr/>
          </p:nvCxnSpPr>
          <p:spPr>
            <a:xfrm>
              <a:off x="4259067" y="2458193"/>
              <a:ext cx="16613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40589C14-A290-A2B0-0530-878E484B52F8}"/>
              </a:ext>
            </a:extLst>
          </p:cNvPr>
          <p:cNvSpPr txBox="1"/>
          <p:nvPr/>
        </p:nvSpPr>
        <p:spPr>
          <a:xfrm>
            <a:off x="10994236" y="6488668"/>
            <a:ext cx="1197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4C</a:t>
            </a:r>
          </a:p>
        </p:txBody>
      </p: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8DA857FD-B176-E93C-672A-A09235F4B4E9}"/>
              </a:ext>
            </a:extLst>
          </p:cNvPr>
          <p:cNvCxnSpPr>
            <a:cxnSpLocks/>
          </p:cNvCxnSpPr>
          <p:nvPr/>
        </p:nvCxnSpPr>
        <p:spPr>
          <a:xfrm>
            <a:off x="932693" y="4028761"/>
            <a:ext cx="930477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Rectangle 22">
            <a:extLst>
              <a:ext uri="{FF2B5EF4-FFF2-40B4-BE49-F238E27FC236}">
                <a16:creationId xmlns:a16="http://schemas.microsoft.com/office/drawing/2014/main" id="{4544689F-909C-2EDC-10E4-340E8DDE119A}"/>
              </a:ext>
            </a:extLst>
          </p:cNvPr>
          <p:cNvSpPr/>
          <p:nvPr/>
        </p:nvSpPr>
        <p:spPr>
          <a:xfrm>
            <a:off x="2000923" y="3754419"/>
            <a:ext cx="8487784" cy="62394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34C1051-37A0-7E2F-D059-7E90A29CCD20}"/>
              </a:ext>
            </a:extLst>
          </p:cNvPr>
          <p:cNvSpPr txBox="1"/>
          <p:nvPr/>
        </p:nvSpPr>
        <p:spPr>
          <a:xfrm>
            <a:off x="94002" y="3762487"/>
            <a:ext cx="838691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p-AKT</a:t>
            </a:r>
          </a:p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S473)</a:t>
            </a:r>
          </a:p>
        </p:txBody>
      </p:sp>
    </p:spTree>
    <p:extLst>
      <p:ext uri="{BB962C8B-B14F-4D97-AF65-F5344CB8AC3E}">
        <p14:creationId xmlns:p14="http://schemas.microsoft.com/office/powerpoint/2010/main" val="7903758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 descr="A black and white photo of a white rectangular object&#10;&#10;Description automatically generated">
            <a:extLst>
              <a:ext uri="{FF2B5EF4-FFF2-40B4-BE49-F238E27FC236}">
                <a16:creationId xmlns:a16="http://schemas.microsoft.com/office/drawing/2014/main" id="{55E96980-0ABA-26D9-7321-61F5E1F21C5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341" t="-594" r="1029" b="95"/>
          <a:stretch/>
        </p:blipFill>
        <p:spPr>
          <a:xfrm>
            <a:off x="859645" y="1160957"/>
            <a:ext cx="10672354" cy="5098254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39" name="Group 38">
            <a:extLst>
              <a:ext uri="{FF2B5EF4-FFF2-40B4-BE49-F238E27FC236}">
                <a16:creationId xmlns:a16="http://schemas.microsoft.com/office/drawing/2014/main" id="{26E52161-C3DC-BF96-6AD6-CCCD04FAC12C}"/>
              </a:ext>
            </a:extLst>
          </p:cNvPr>
          <p:cNvGrpSpPr/>
          <p:nvPr/>
        </p:nvGrpSpPr>
        <p:grpSpPr>
          <a:xfrm>
            <a:off x="2448416" y="-70904"/>
            <a:ext cx="1383751" cy="370841"/>
            <a:chOff x="2105314" y="853068"/>
            <a:chExt cx="3612995" cy="370841"/>
          </a:xfrm>
        </p:grpSpPr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0D92A6C5-A7EF-F766-4BF4-85DE7F1A67E6}"/>
                </a:ext>
              </a:extLst>
            </p:cNvPr>
            <p:cNvCxnSpPr/>
            <p:nvPr/>
          </p:nvCxnSpPr>
          <p:spPr>
            <a:xfrm>
              <a:off x="2105314" y="1223909"/>
              <a:ext cx="361299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9E76A1CE-876B-FFF4-0A6A-8A23631FBA2D}"/>
                </a:ext>
              </a:extLst>
            </p:cNvPr>
            <p:cNvSpPr txBox="1"/>
            <p:nvPr/>
          </p:nvSpPr>
          <p:spPr>
            <a:xfrm>
              <a:off x="2105314" y="853068"/>
              <a:ext cx="36129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Fasted</a:t>
              </a:r>
            </a:p>
          </p:txBody>
        </p:sp>
      </p:grpSp>
      <p:grpSp>
        <p:nvGrpSpPr>
          <p:cNvPr id="22" name="Group 21">
            <a:extLst>
              <a:ext uri="{FF2B5EF4-FFF2-40B4-BE49-F238E27FC236}">
                <a16:creationId xmlns:a16="http://schemas.microsoft.com/office/drawing/2014/main" id="{C8154DDE-6C94-B1C7-B0FE-8BF5097C0469}"/>
              </a:ext>
            </a:extLst>
          </p:cNvPr>
          <p:cNvGrpSpPr/>
          <p:nvPr/>
        </p:nvGrpSpPr>
        <p:grpSpPr>
          <a:xfrm>
            <a:off x="4355502" y="-70149"/>
            <a:ext cx="6598215" cy="369332"/>
            <a:chOff x="6592727" y="1885435"/>
            <a:chExt cx="3646100" cy="369332"/>
          </a:xfrm>
        </p:grpSpPr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0BB49961-E24D-BCAF-B673-428585BE77FE}"/>
                </a:ext>
              </a:extLst>
            </p:cNvPr>
            <p:cNvCxnSpPr>
              <a:cxnSpLocks/>
            </p:cNvCxnSpPr>
            <p:nvPr/>
          </p:nvCxnSpPr>
          <p:spPr>
            <a:xfrm>
              <a:off x="6592727" y="2253258"/>
              <a:ext cx="361299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F0486AE8-A58B-8CC0-1EC5-8E96FA4DB46E}"/>
                </a:ext>
              </a:extLst>
            </p:cNvPr>
            <p:cNvSpPr txBox="1"/>
            <p:nvPr/>
          </p:nvSpPr>
          <p:spPr>
            <a:xfrm>
              <a:off x="6625833" y="1885435"/>
              <a:ext cx="36129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Refed</a:t>
              </a:r>
            </a:p>
          </p:txBody>
        </p:sp>
      </p:grpSp>
      <p:grpSp>
        <p:nvGrpSpPr>
          <p:cNvPr id="59" name="Group 58">
            <a:extLst>
              <a:ext uri="{FF2B5EF4-FFF2-40B4-BE49-F238E27FC236}">
                <a16:creationId xmlns:a16="http://schemas.microsoft.com/office/drawing/2014/main" id="{D4426270-B8D8-45D6-8EBB-4463B9AE23DD}"/>
              </a:ext>
            </a:extLst>
          </p:cNvPr>
          <p:cNvGrpSpPr/>
          <p:nvPr/>
        </p:nvGrpSpPr>
        <p:grpSpPr>
          <a:xfrm>
            <a:off x="8982556" y="330373"/>
            <a:ext cx="2011680" cy="646331"/>
            <a:chOff x="4259067" y="1880514"/>
            <a:chExt cx="1661336" cy="646331"/>
          </a:xfrm>
        </p:grpSpPr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99329D17-994D-F884-E452-95D92622B260}"/>
                </a:ext>
              </a:extLst>
            </p:cNvPr>
            <p:cNvSpPr txBox="1"/>
            <p:nvPr/>
          </p:nvSpPr>
          <p:spPr>
            <a:xfrm>
              <a:off x="4259067" y="1880514"/>
              <a:ext cx="166133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L-Raptor-KO </a:t>
              </a:r>
            </a:p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+ PPP1R3B</a:t>
              </a:r>
            </a:p>
          </p:txBody>
        </p:sp>
        <p:cxnSp>
          <p:nvCxnSpPr>
            <p:cNvPr id="61" name="Straight Connector 60">
              <a:extLst>
                <a:ext uri="{FF2B5EF4-FFF2-40B4-BE49-F238E27FC236}">
                  <a16:creationId xmlns:a16="http://schemas.microsoft.com/office/drawing/2014/main" id="{8A68CAF4-BA67-8119-9AC9-BC90C7189CA2}"/>
                </a:ext>
              </a:extLst>
            </p:cNvPr>
            <p:cNvCxnSpPr>
              <a:cxnSpLocks/>
            </p:cNvCxnSpPr>
            <p:nvPr/>
          </p:nvCxnSpPr>
          <p:spPr>
            <a:xfrm>
              <a:off x="4259067" y="2481639"/>
              <a:ext cx="16613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07E0DFBD-4120-9239-5910-60ABF9AA6F83}"/>
              </a:ext>
            </a:extLst>
          </p:cNvPr>
          <p:cNvGrpSpPr/>
          <p:nvPr/>
        </p:nvGrpSpPr>
        <p:grpSpPr>
          <a:xfrm>
            <a:off x="4174436" y="566781"/>
            <a:ext cx="2012691" cy="369332"/>
            <a:chOff x="4259067" y="2088861"/>
            <a:chExt cx="1661336" cy="369332"/>
          </a:xfrm>
        </p:grpSpPr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A2C9EBAC-F98A-CC03-2757-E5137C6DBFAF}"/>
                </a:ext>
              </a:extLst>
            </p:cNvPr>
            <p:cNvSpPr txBox="1"/>
            <p:nvPr/>
          </p:nvSpPr>
          <p:spPr>
            <a:xfrm>
              <a:off x="4259067" y="2088861"/>
              <a:ext cx="16613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31D585D7-359E-F740-7F4E-9619588B481D}"/>
                </a:ext>
              </a:extLst>
            </p:cNvPr>
            <p:cNvCxnSpPr>
              <a:cxnSpLocks/>
            </p:cNvCxnSpPr>
            <p:nvPr/>
          </p:nvCxnSpPr>
          <p:spPr>
            <a:xfrm>
              <a:off x="4259067" y="2458193"/>
              <a:ext cx="16613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D0AFA08F-802F-1A09-8A39-53023500505A}"/>
              </a:ext>
            </a:extLst>
          </p:cNvPr>
          <p:cNvGrpSpPr/>
          <p:nvPr/>
        </p:nvGrpSpPr>
        <p:grpSpPr>
          <a:xfrm>
            <a:off x="6574151" y="566781"/>
            <a:ext cx="2011680" cy="369332"/>
            <a:chOff x="4259067" y="2088861"/>
            <a:chExt cx="1661336" cy="369332"/>
          </a:xfrm>
        </p:grpSpPr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EF0DADD5-0075-99F5-5C7A-CA046CD7D3FC}"/>
                </a:ext>
              </a:extLst>
            </p:cNvPr>
            <p:cNvSpPr txBox="1"/>
            <p:nvPr/>
          </p:nvSpPr>
          <p:spPr>
            <a:xfrm>
              <a:off x="4259067" y="2088861"/>
              <a:ext cx="16613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L-Raptor-KO</a:t>
              </a:r>
            </a:p>
          </p:txBody>
        </p: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1C91D279-92D7-2AA5-135C-4F97F0FD7F72}"/>
                </a:ext>
              </a:extLst>
            </p:cNvPr>
            <p:cNvCxnSpPr>
              <a:cxnSpLocks/>
            </p:cNvCxnSpPr>
            <p:nvPr/>
          </p:nvCxnSpPr>
          <p:spPr>
            <a:xfrm>
              <a:off x="4259067" y="2458193"/>
              <a:ext cx="16613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" name="Group 17">
            <a:extLst>
              <a:ext uri="{FF2B5EF4-FFF2-40B4-BE49-F238E27FC236}">
                <a16:creationId xmlns:a16="http://schemas.microsoft.com/office/drawing/2014/main" id="{4B038CB6-8EC8-E154-6B41-ADBF45A29F70}"/>
              </a:ext>
            </a:extLst>
          </p:cNvPr>
          <p:cNvGrpSpPr/>
          <p:nvPr/>
        </p:nvGrpSpPr>
        <p:grpSpPr>
          <a:xfrm>
            <a:off x="2448416" y="566781"/>
            <a:ext cx="1383751" cy="369332"/>
            <a:chOff x="4259067" y="2088861"/>
            <a:chExt cx="1661336" cy="369332"/>
          </a:xfrm>
        </p:grpSpPr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87FE6A94-630C-FE23-741A-AE1454E85780}"/>
                </a:ext>
              </a:extLst>
            </p:cNvPr>
            <p:cNvSpPr txBox="1"/>
            <p:nvPr/>
          </p:nvSpPr>
          <p:spPr>
            <a:xfrm>
              <a:off x="4259067" y="2088861"/>
              <a:ext cx="16613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E9C0FE81-F752-BF54-038F-B5FDEA75752E}"/>
                </a:ext>
              </a:extLst>
            </p:cNvPr>
            <p:cNvCxnSpPr>
              <a:cxnSpLocks/>
            </p:cNvCxnSpPr>
            <p:nvPr/>
          </p:nvCxnSpPr>
          <p:spPr>
            <a:xfrm>
              <a:off x="4259067" y="2458193"/>
              <a:ext cx="16613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0" name="TextBox 29">
            <a:extLst>
              <a:ext uri="{FF2B5EF4-FFF2-40B4-BE49-F238E27FC236}">
                <a16:creationId xmlns:a16="http://schemas.microsoft.com/office/drawing/2014/main" id="{44B716B8-2AC8-0DC2-CAD5-16E097CA738E}"/>
              </a:ext>
            </a:extLst>
          </p:cNvPr>
          <p:cNvSpPr txBox="1"/>
          <p:nvPr/>
        </p:nvSpPr>
        <p:spPr>
          <a:xfrm>
            <a:off x="-83241" y="4813170"/>
            <a:ext cx="942886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p-S6</a:t>
            </a:r>
          </a:p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S240/244)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0589C14-A290-A2B0-0530-878E484B52F8}"/>
              </a:ext>
            </a:extLst>
          </p:cNvPr>
          <p:cNvSpPr txBox="1"/>
          <p:nvPr/>
        </p:nvSpPr>
        <p:spPr>
          <a:xfrm>
            <a:off x="10994236" y="6488668"/>
            <a:ext cx="1197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4C</a:t>
            </a:r>
          </a:p>
        </p:txBody>
      </p: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088BBEF5-9931-EFBD-22FF-ABBA4C385CDD}"/>
              </a:ext>
            </a:extLst>
          </p:cNvPr>
          <p:cNvCxnSpPr>
            <a:cxnSpLocks/>
          </p:cNvCxnSpPr>
          <p:nvPr/>
        </p:nvCxnSpPr>
        <p:spPr>
          <a:xfrm>
            <a:off x="773044" y="5073022"/>
            <a:ext cx="676933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Rectangle 12">
            <a:extLst>
              <a:ext uri="{FF2B5EF4-FFF2-40B4-BE49-F238E27FC236}">
                <a16:creationId xmlns:a16="http://schemas.microsoft.com/office/drawing/2014/main" id="{E2365C63-C532-9D0E-3733-0B852B348625}"/>
              </a:ext>
            </a:extLst>
          </p:cNvPr>
          <p:cNvSpPr/>
          <p:nvPr/>
        </p:nvSpPr>
        <p:spPr>
          <a:xfrm>
            <a:off x="2306262" y="4403819"/>
            <a:ext cx="8974183" cy="129322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591397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black and white photo of a grid&#10;&#10;Description automatically generated">
            <a:extLst>
              <a:ext uri="{FF2B5EF4-FFF2-40B4-BE49-F238E27FC236}">
                <a16:creationId xmlns:a16="http://schemas.microsoft.com/office/drawing/2014/main" id="{EB76A49C-88D1-CDFF-C6EC-CE867BCC61E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40" t="1852" r="621" b="2890"/>
          <a:stretch/>
        </p:blipFill>
        <p:spPr>
          <a:xfrm>
            <a:off x="1502259" y="1015619"/>
            <a:ext cx="9577956" cy="2877124"/>
          </a:xfrm>
          <a:prstGeom prst="rect">
            <a:avLst/>
          </a:prstGeom>
          <a:ln>
            <a:noFill/>
          </a:ln>
        </p:spPr>
      </p:pic>
      <p:grpSp>
        <p:nvGrpSpPr>
          <p:cNvPr id="39" name="Group 38">
            <a:extLst>
              <a:ext uri="{FF2B5EF4-FFF2-40B4-BE49-F238E27FC236}">
                <a16:creationId xmlns:a16="http://schemas.microsoft.com/office/drawing/2014/main" id="{26E52161-C3DC-BF96-6AD6-CCCD04FAC12C}"/>
              </a:ext>
            </a:extLst>
          </p:cNvPr>
          <p:cNvGrpSpPr/>
          <p:nvPr/>
        </p:nvGrpSpPr>
        <p:grpSpPr>
          <a:xfrm>
            <a:off x="2448416" y="-70904"/>
            <a:ext cx="1383751" cy="370841"/>
            <a:chOff x="2105314" y="853068"/>
            <a:chExt cx="3612995" cy="370841"/>
          </a:xfrm>
        </p:grpSpPr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0D92A6C5-A7EF-F766-4BF4-85DE7F1A67E6}"/>
                </a:ext>
              </a:extLst>
            </p:cNvPr>
            <p:cNvCxnSpPr/>
            <p:nvPr/>
          </p:nvCxnSpPr>
          <p:spPr>
            <a:xfrm>
              <a:off x="2105314" y="1223909"/>
              <a:ext cx="361299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9E76A1CE-876B-FFF4-0A6A-8A23631FBA2D}"/>
                </a:ext>
              </a:extLst>
            </p:cNvPr>
            <p:cNvSpPr txBox="1"/>
            <p:nvPr/>
          </p:nvSpPr>
          <p:spPr>
            <a:xfrm>
              <a:off x="2105314" y="853068"/>
              <a:ext cx="36129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Fasted</a:t>
              </a:r>
            </a:p>
          </p:txBody>
        </p:sp>
      </p:grpSp>
      <p:grpSp>
        <p:nvGrpSpPr>
          <p:cNvPr id="22" name="Group 21">
            <a:extLst>
              <a:ext uri="{FF2B5EF4-FFF2-40B4-BE49-F238E27FC236}">
                <a16:creationId xmlns:a16="http://schemas.microsoft.com/office/drawing/2014/main" id="{C8154DDE-6C94-B1C7-B0FE-8BF5097C0469}"/>
              </a:ext>
            </a:extLst>
          </p:cNvPr>
          <p:cNvGrpSpPr/>
          <p:nvPr/>
        </p:nvGrpSpPr>
        <p:grpSpPr>
          <a:xfrm>
            <a:off x="4355502" y="-70149"/>
            <a:ext cx="6598215" cy="369332"/>
            <a:chOff x="6592727" y="1885435"/>
            <a:chExt cx="3646100" cy="369332"/>
          </a:xfrm>
        </p:grpSpPr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0BB49961-E24D-BCAF-B673-428585BE77FE}"/>
                </a:ext>
              </a:extLst>
            </p:cNvPr>
            <p:cNvCxnSpPr>
              <a:cxnSpLocks/>
            </p:cNvCxnSpPr>
            <p:nvPr/>
          </p:nvCxnSpPr>
          <p:spPr>
            <a:xfrm>
              <a:off x="6592727" y="2253258"/>
              <a:ext cx="361299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F0486AE8-A58B-8CC0-1EC5-8E96FA4DB46E}"/>
                </a:ext>
              </a:extLst>
            </p:cNvPr>
            <p:cNvSpPr txBox="1"/>
            <p:nvPr/>
          </p:nvSpPr>
          <p:spPr>
            <a:xfrm>
              <a:off x="6625833" y="1885435"/>
              <a:ext cx="36129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Refed</a:t>
              </a:r>
            </a:p>
          </p:txBody>
        </p:sp>
      </p:grpSp>
      <p:grpSp>
        <p:nvGrpSpPr>
          <p:cNvPr id="59" name="Group 58">
            <a:extLst>
              <a:ext uri="{FF2B5EF4-FFF2-40B4-BE49-F238E27FC236}">
                <a16:creationId xmlns:a16="http://schemas.microsoft.com/office/drawing/2014/main" id="{D4426270-B8D8-45D6-8EBB-4463B9AE23DD}"/>
              </a:ext>
            </a:extLst>
          </p:cNvPr>
          <p:cNvGrpSpPr/>
          <p:nvPr/>
        </p:nvGrpSpPr>
        <p:grpSpPr>
          <a:xfrm>
            <a:off x="8982556" y="330373"/>
            <a:ext cx="2011680" cy="646331"/>
            <a:chOff x="4259067" y="1880514"/>
            <a:chExt cx="1661336" cy="646331"/>
          </a:xfrm>
        </p:grpSpPr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99329D17-994D-F884-E452-95D92622B260}"/>
                </a:ext>
              </a:extLst>
            </p:cNvPr>
            <p:cNvSpPr txBox="1"/>
            <p:nvPr/>
          </p:nvSpPr>
          <p:spPr>
            <a:xfrm>
              <a:off x="4259067" y="1880514"/>
              <a:ext cx="166133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L-Raptor-KO </a:t>
              </a:r>
            </a:p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+ PPP1R3B</a:t>
              </a:r>
            </a:p>
          </p:txBody>
        </p:sp>
        <p:cxnSp>
          <p:nvCxnSpPr>
            <p:cNvPr id="61" name="Straight Connector 60">
              <a:extLst>
                <a:ext uri="{FF2B5EF4-FFF2-40B4-BE49-F238E27FC236}">
                  <a16:creationId xmlns:a16="http://schemas.microsoft.com/office/drawing/2014/main" id="{8A68CAF4-BA67-8119-9AC9-BC90C7189CA2}"/>
                </a:ext>
              </a:extLst>
            </p:cNvPr>
            <p:cNvCxnSpPr>
              <a:cxnSpLocks/>
            </p:cNvCxnSpPr>
            <p:nvPr/>
          </p:nvCxnSpPr>
          <p:spPr>
            <a:xfrm>
              <a:off x="4259067" y="2481639"/>
              <a:ext cx="16613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07E0DFBD-4120-9239-5910-60ABF9AA6F83}"/>
              </a:ext>
            </a:extLst>
          </p:cNvPr>
          <p:cNvGrpSpPr/>
          <p:nvPr/>
        </p:nvGrpSpPr>
        <p:grpSpPr>
          <a:xfrm>
            <a:off x="4174436" y="566781"/>
            <a:ext cx="2012691" cy="369332"/>
            <a:chOff x="4259067" y="2088861"/>
            <a:chExt cx="1661336" cy="369332"/>
          </a:xfrm>
        </p:grpSpPr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A2C9EBAC-F98A-CC03-2757-E5137C6DBFAF}"/>
                </a:ext>
              </a:extLst>
            </p:cNvPr>
            <p:cNvSpPr txBox="1"/>
            <p:nvPr/>
          </p:nvSpPr>
          <p:spPr>
            <a:xfrm>
              <a:off x="4259067" y="2088861"/>
              <a:ext cx="16613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31D585D7-359E-F740-7F4E-9619588B481D}"/>
                </a:ext>
              </a:extLst>
            </p:cNvPr>
            <p:cNvCxnSpPr>
              <a:cxnSpLocks/>
            </p:cNvCxnSpPr>
            <p:nvPr/>
          </p:nvCxnSpPr>
          <p:spPr>
            <a:xfrm>
              <a:off x="4259067" y="2458193"/>
              <a:ext cx="16613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D0AFA08F-802F-1A09-8A39-53023500505A}"/>
              </a:ext>
            </a:extLst>
          </p:cNvPr>
          <p:cNvGrpSpPr/>
          <p:nvPr/>
        </p:nvGrpSpPr>
        <p:grpSpPr>
          <a:xfrm>
            <a:off x="6574151" y="566781"/>
            <a:ext cx="2011680" cy="369332"/>
            <a:chOff x="4259067" y="2088861"/>
            <a:chExt cx="1661336" cy="369332"/>
          </a:xfrm>
        </p:grpSpPr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EF0DADD5-0075-99F5-5C7A-CA046CD7D3FC}"/>
                </a:ext>
              </a:extLst>
            </p:cNvPr>
            <p:cNvSpPr txBox="1"/>
            <p:nvPr/>
          </p:nvSpPr>
          <p:spPr>
            <a:xfrm>
              <a:off x="4259067" y="2088861"/>
              <a:ext cx="16613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L-Raptor-KO</a:t>
              </a:r>
            </a:p>
          </p:txBody>
        </p: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1C91D279-92D7-2AA5-135C-4F97F0FD7F72}"/>
                </a:ext>
              </a:extLst>
            </p:cNvPr>
            <p:cNvCxnSpPr>
              <a:cxnSpLocks/>
            </p:cNvCxnSpPr>
            <p:nvPr/>
          </p:nvCxnSpPr>
          <p:spPr>
            <a:xfrm>
              <a:off x="4259067" y="2458193"/>
              <a:ext cx="16613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" name="Group 17">
            <a:extLst>
              <a:ext uri="{FF2B5EF4-FFF2-40B4-BE49-F238E27FC236}">
                <a16:creationId xmlns:a16="http://schemas.microsoft.com/office/drawing/2014/main" id="{4B038CB6-8EC8-E154-6B41-ADBF45A29F70}"/>
              </a:ext>
            </a:extLst>
          </p:cNvPr>
          <p:cNvGrpSpPr/>
          <p:nvPr/>
        </p:nvGrpSpPr>
        <p:grpSpPr>
          <a:xfrm>
            <a:off x="2448416" y="566781"/>
            <a:ext cx="1383751" cy="369332"/>
            <a:chOff x="4259067" y="2088861"/>
            <a:chExt cx="1661336" cy="369332"/>
          </a:xfrm>
        </p:grpSpPr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87FE6A94-630C-FE23-741A-AE1454E85780}"/>
                </a:ext>
              </a:extLst>
            </p:cNvPr>
            <p:cNvSpPr txBox="1"/>
            <p:nvPr/>
          </p:nvSpPr>
          <p:spPr>
            <a:xfrm>
              <a:off x="4259067" y="2088861"/>
              <a:ext cx="16613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E9C0FE81-F752-BF54-038F-B5FDEA75752E}"/>
                </a:ext>
              </a:extLst>
            </p:cNvPr>
            <p:cNvCxnSpPr>
              <a:cxnSpLocks/>
            </p:cNvCxnSpPr>
            <p:nvPr/>
          </p:nvCxnSpPr>
          <p:spPr>
            <a:xfrm>
              <a:off x="4259067" y="2458193"/>
              <a:ext cx="16613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0" name="TextBox 29">
            <a:extLst>
              <a:ext uri="{FF2B5EF4-FFF2-40B4-BE49-F238E27FC236}">
                <a16:creationId xmlns:a16="http://schemas.microsoft.com/office/drawing/2014/main" id="{44B716B8-2AC8-0DC2-CAD5-16E097CA738E}"/>
              </a:ext>
            </a:extLst>
          </p:cNvPr>
          <p:cNvSpPr txBox="1"/>
          <p:nvPr/>
        </p:nvSpPr>
        <p:spPr>
          <a:xfrm>
            <a:off x="-51837" y="2048455"/>
            <a:ext cx="87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Raptor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0589C14-A290-A2B0-0530-878E484B52F8}"/>
              </a:ext>
            </a:extLst>
          </p:cNvPr>
          <p:cNvSpPr txBox="1"/>
          <p:nvPr/>
        </p:nvSpPr>
        <p:spPr>
          <a:xfrm>
            <a:off x="10994236" y="6488668"/>
            <a:ext cx="1197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4C</a:t>
            </a:r>
          </a:p>
        </p:txBody>
      </p: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088BBEF5-9931-EFBD-22FF-ABBA4C385CDD}"/>
              </a:ext>
            </a:extLst>
          </p:cNvPr>
          <p:cNvCxnSpPr>
            <a:cxnSpLocks/>
          </p:cNvCxnSpPr>
          <p:nvPr/>
        </p:nvCxnSpPr>
        <p:spPr>
          <a:xfrm>
            <a:off x="825326" y="2233121"/>
            <a:ext cx="676933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Rectangle 12">
            <a:extLst>
              <a:ext uri="{FF2B5EF4-FFF2-40B4-BE49-F238E27FC236}">
                <a16:creationId xmlns:a16="http://schemas.microsoft.com/office/drawing/2014/main" id="{E2365C63-C532-9D0E-3733-0B852B348625}"/>
              </a:ext>
            </a:extLst>
          </p:cNvPr>
          <p:cNvSpPr/>
          <p:nvPr/>
        </p:nvSpPr>
        <p:spPr>
          <a:xfrm>
            <a:off x="2106033" y="2417787"/>
            <a:ext cx="8328886" cy="56782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473750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 descr="A black and white photo of a grid&#10;&#10;Description automatically generated">
            <a:extLst>
              <a:ext uri="{FF2B5EF4-FFF2-40B4-BE49-F238E27FC236}">
                <a16:creationId xmlns:a16="http://schemas.microsoft.com/office/drawing/2014/main" id="{2F8D53CB-63CD-874F-0E5C-C7C3C0C8873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13" t="2128" r="637" b="947"/>
          <a:stretch/>
        </p:blipFill>
        <p:spPr>
          <a:xfrm>
            <a:off x="666157" y="2143900"/>
            <a:ext cx="11051177" cy="3360353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39" name="Group 38">
            <a:extLst>
              <a:ext uri="{FF2B5EF4-FFF2-40B4-BE49-F238E27FC236}">
                <a16:creationId xmlns:a16="http://schemas.microsoft.com/office/drawing/2014/main" id="{26E52161-C3DC-BF96-6AD6-CCCD04FAC12C}"/>
              </a:ext>
            </a:extLst>
          </p:cNvPr>
          <p:cNvGrpSpPr/>
          <p:nvPr/>
        </p:nvGrpSpPr>
        <p:grpSpPr>
          <a:xfrm>
            <a:off x="2261038" y="981465"/>
            <a:ext cx="1383751" cy="370841"/>
            <a:chOff x="2105314" y="853068"/>
            <a:chExt cx="3612995" cy="370841"/>
          </a:xfrm>
        </p:grpSpPr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0D92A6C5-A7EF-F766-4BF4-85DE7F1A67E6}"/>
                </a:ext>
              </a:extLst>
            </p:cNvPr>
            <p:cNvCxnSpPr/>
            <p:nvPr/>
          </p:nvCxnSpPr>
          <p:spPr>
            <a:xfrm>
              <a:off x="2105314" y="1223909"/>
              <a:ext cx="361299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9E76A1CE-876B-FFF4-0A6A-8A23631FBA2D}"/>
                </a:ext>
              </a:extLst>
            </p:cNvPr>
            <p:cNvSpPr txBox="1"/>
            <p:nvPr/>
          </p:nvSpPr>
          <p:spPr>
            <a:xfrm>
              <a:off x="2105314" y="853068"/>
              <a:ext cx="36129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Fasted</a:t>
              </a:r>
            </a:p>
          </p:txBody>
        </p:sp>
      </p:grpSp>
      <p:grpSp>
        <p:nvGrpSpPr>
          <p:cNvPr id="22" name="Group 21">
            <a:extLst>
              <a:ext uri="{FF2B5EF4-FFF2-40B4-BE49-F238E27FC236}">
                <a16:creationId xmlns:a16="http://schemas.microsoft.com/office/drawing/2014/main" id="{C8154DDE-6C94-B1C7-B0FE-8BF5097C0469}"/>
              </a:ext>
            </a:extLst>
          </p:cNvPr>
          <p:cNvGrpSpPr/>
          <p:nvPr/>
        </p:nvGrpSpPr>
        <p:grpSpPr>
          <a:xfrm>
            <a:off x="4168124" y="982220"/>
            <a:ext cx="6598215" cy="369332"/>
            <a:chOff x="6592727" y="1885435"/>
            <a:chExt cx="3646100" cy="369332"/>
          </a:xfrm>
        </p:grpSpPr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0BB49961-E24D-BCAF-B673-428585BE77FE}"/>
                </a:ext>
              </a:extLst>
            </p:cNvPr>
            <p:cNvCxnSpPr>
              <a:cxnSpLocks/>
            </p:cNvCxnSpPr>
            <p:nvPr/>
          </p:nvCxnSpPr>
          <p:spPr>
            <a:xfrm>
              <a:off x="6592727" y="2253258"/>
              <a:ext cx="361299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F0486AE8-A58B-8CC0-1EC5-8E96FA4DB46E}"/>
                </a:ext>
              </a:extLst>
            </p:cNvPr>
            <p:cNvSpPr txBox="1"/>
            <p:nvPr/>
          </p:nvSpPr>
          <p:spPr>
            <a:xfrm>
              <a:off x="6625833" y="1885435"/>
              <a:ext cx="36129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Refed</a:t>
              </a:r>
            </a:p>
          </p:txBody>
        </p:sp>
      </p:grpSp>
      <p:grpSp>
        <p:nvGrpSpPr>
          <p:cNvPr id="59" name="Group 58">
            <a:extLst>
              <a:ext uri="{FF2B5EF4-FFF2-40B4-BE49-F238E27FC236}">
                <a16:creationId xmlns:a16="http://schemas.microsoft.com/office/drawing/2014/main" id="{D4426270-B8D8-45D6-8EBB-4463B9AE23DD}"/>
              </a:ext>
            </a:extLst>
          </p:cNvPr>
          <p:cNvGrpSpPr/>
          <p:nvPr/>
        </p:nvGrpSpPr>
        <p:grpSpPr>
          <a:xfrm>
            <a:off x="8795178" y="1382742"/>
            <a:ext cx="2011680" cy="646331"/>
            <a:chOff x="4259067" y="1880514"/>
            <a:chExt cx="1661336" cy="646331"/>
          </a:xfrm>
        </p:grpSpPr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99329D17-994D-F884-E452-95D92622B260}"/>
                </a:ext>
              </a:extLst>
            </p:cNvPr>
            <p:cNvSpPr txBox="1"/>
            <p:nvPr/>
          </p:nvSpPr>
          <p:spPr>
            <a:xfrm>
              <a:off x="4259067" y="1880514"/>
              <a:ext cx="166133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L-Raptor-KO </a:t>
              </a:r>
            </a:p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+ PPP1R3B</a:t>
              </a:r>
            </a:p>
          </p:txBody>
        </p:sp>
        <p:cxnSp>
          <p:nvCxnSpPr>
            <p:cNvPr id="61" name="Straight Connector 60">
              <a:extLst>
                <a:ext uri="{FF2B5EF4-FFF2-40B4-BE49-F238E27FC236}">
                  <a16:creationId xmlns:a16="http://schemas.microsoft.com/office/drawing/2014/main" id="{8A68CAF4-BA67-8119-9AC9-BC90C7189CA2}"/>
                </a:ext>
              </a:extLst>
            </p:cNvPr>
            <p:cNvCxnSpPr>
              <a:cxnSpLocks/>
            </p:cNvCxnSpPr>
            <p:nvPr/>
          </p:nvCxnSpPr>
          <p:spPr>
            <a:xfrm>
              <a:off x="4259067" y="2481639"/>
              <a:ext cx="16613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07E0DFBD-4120-9239-5910-60ABF9AA6F83}"/>
              </a:ext>
            </a:extLst>
          </p:cNvPr>
          <p:cNvGrpSpPr/>
          <p:nvPr/>
        </p:nvGrpSpPr>
        <p:grpSpPr>
          <a:xfrm>
            <a:off x="3987058" y="1619150"/>
            <a:ext cx="2012691" cy="369332"/>
            <a:chOff x="4259067" y="2088861"/>
            <a:chExt cx="1661336" cy="369332"/>
          </a:xfrm>
        </p:grpSpPr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A2C9EBAC-F98A-CC03-2757-E5137C6DBFAF}"/>
                </a:ext>
              </a:extLst>
            </p:cNvPr>
            <p:cNvSpPr txBox="1"/>
            <p:nvPr/>
          </p:nvSpPr>
          <p:spPr>
            <a:xfrm>
              <a:off x="4259067" y="2088861"/>
              <a:ext cx="16613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31D585D7-359E-F740-7F4E-9619588B481D}"/>
                </a:ext>
              </a:extLst>
            </p:cNvPr>
            <p:cNvCxnSpPr>
              <a:cxnSpLocks/>
            </p:cNvCxnSpPr>
            <p:nvPr/>
          </p:nvCxnSpPr>
          <p:spPr>
            <a:xfrm>
              <a:off x="4259067" y="2458193"/>
              <a:ext cx="16613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D0AFA08F-802F-1A09-8A39-53023500505A}"/>
              </a:ext>
            </a:extLst>
          </p:cNvPr>
          <p:cNvGrpSpPr/>
          <p:nvPr/>
        </p:nvGrpSpPr>
        <p:grpSpPr>
          <a:xfrm>
            <a:off x="6386773" y="1619150"/>
            <a:ext cx="2011680" cy="369332"/>
            <a:chOff x="4259067" y="2088861"/>
            <a:chExt cx="1661336" cy="369332"/>
          </a:xfrm>
        </p:grpSpPr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EF0DADD5-0075-99F5-5C7A-CA046CD7D3FC}"/>
                </a:ext>
              </a:extLst>
            </p:cNvPr>
            <p:cNvSpPr txBox="1"/>
            <p:nvPr/>
          </p:nvSpPr>
          <p:spPr>
            <a:xfrm>
              <a:off x="4259067" y="2088861"/>
              <a:ext cx="16613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L-Raptor-KO</a:t>
              </a:r>
            </a:p>
          </p:txBody>
        </p: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1C91D279-92D7-2AA5-135C-4F97F0FD7F72}"/>
                </a:ext>
              </a:extLst>
            </p:cNvPr>
            <p:cNvCxnSpPr>
              <a:cxnSpLocks/>
            </p:cNvCxnSpPr>
            <p:nvPr/>
          </p:nvCxnSpPr>
          <p:spPr>
            <a:xfrm>
              <a:off x="4259067" y="2458193"/>
              <a:ext cx="16613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" name="Group 17">
            <a:extLst>
              <a:ext uri="{FF2B5EF4-FFF2-40B4-BE49-F238E27FC236}">
                <a16:creationId xmlns:a16="http://schemas.microsoft.com/office/drawing/2014/main" id="{4B038CB6-8EC8-E154-6B41-ADBF45A29F70}"/>
              </a:ext>
            </a:extLst>
          </p:cNvPr>
          <p:cNvGrpSpPr/>
          <p:nvPr/>
        </p:nvGrpSpPr>
        <p:grpSpPr>
          <a:xfrm>
            <a:off x="2261038" y="1619150"/>
            <a:ext cx="1383751" cy="369332"/>
            <a:chOff x="4259067" y="2088861"/>
            <a:chExt cx="1661336" cy="369332"/>
          </a:xfrm>
        </p:grpSpPr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87FE6A94-630C-FE23-741A-AE1454E85780}"/>
                </a:ext>
              </a:extLst>
            </p:cNvPr>
            <p:cNvSpPr txBox="1"/>
            <p:nvPr/>
          </p:nvSpPr>
          <p:spPr>
            <a:xfrm>
              <a:off x="4259067" y="2088861"/>
              <a:ext cx="16613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E9C0FE81-F752-BF54-038F-B5FDEA75752E}"/>
                </a:ext>
              </a:extLst>
            </p:cNvPr>
            <p:cNvCxnSpPr>
              <a:cxnSpLocks/>
            </p:cNvCxnSpPr>
            <p:nvPr/>
          </p:nvCxnSpPr>
          <p:spPr>
            <a:xfrm>
              <a:off x="4259067" y="2458193"/>
              <a:ext cx="16613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33A90207-D800-998A-EC8E-4287D9C84669}"/>
              </a:ext>
            </a:extLst>
          </p:cNvPr>
          <p:cNvSpPr txBox="1"/>
          <p:nvPr/>
        </p:nvSpPr>
        <p:spPr>
          <a:xfrm rot="16200000">
            <a:off x="-167817" y="4548720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HSP90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0589C14-A290-A2B0-0530-878E484B52F8}"/>
              </a:ext>
            </a:extLst>
          </p:cNvPr>
          <p:cNvSpPr txBox="1"/>
          <p:nvPr/>
        </p:nvSpPr>
        <p:spPr>
          <a:xfrm>
            <a:off x="10994236" y="6488668"/>
            <a:ext cx="1197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4C</a:t>
            </a:r>
          </a:p>
        </p:txBody>
      </p: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21D3D62F-6DB9-2CBE-A447-CB08C2578229}"/>
              </a:ext>
            </a:extLst>
          </p:cNvPr>
          <p:cNvCxnSpPr>
            <a:cxnSpLocks/>
          </p:cNvCxnSpPr>
          <p:nvPr/>
        </p:nvCxnSpPr>
        <p:spPr>
          <a:xfrm>
            <a:off x="404949" y="4733387"/>
            <a:ext cx="93814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Rectangle 9">
            <a:extLst>
              <a:ext uri="{FF2B5EF4-FFF2-40B4-BE49-F238E27FC236}">
                <a16:creationId xmlns:a16="http://schemas.microsoft.com/office/drawing/2014/main" id="{840C26DF-367B-9ABC-DCCD-0CBE506600A6}"/>
              </a:ext>
            </a:extLst>
          </p:cNvPr>
          <p:cNvSpPr/>
          <p:nvPr/>
        </p:nvSpPr>
        <p:spPr>
          <a:xfrm>
            <a:off x="1972490" y="4519756"/>
            <a:ext cx="9021745" cy="671445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0778691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close-up of a black and white photo&#10;&#10;Description automatically generated">
            <a:extLst>
              <a:ext uri="{FF2B5EF4-FFF2-40B4-BE49-F238E27FC236}">
                <a16:creationId xmlns:a16="http://schemas.microsoft.com/office/drawing/2014/main" id="{19737C56-FE2C-DBE8-9317-11239D7C1F0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093" t="-565" r="170" b="4039"/>
          <a:stretch/>
        </p:blipFill>
        <p:spPr>
          <a:xfrm>
            <a:off x="2670400" y="1129823"/>
            <a:ext cx="7624667" cy="4330029"/>
          </a:xfrm>
          <a:prstGeom prst="rect">
            <a:avLst/>
          </a:prstGeom>
          <a:ln>
            <a:noFill/>
          </a:ln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736CC22F-CFAD-DC13-24B8-C51287289EEA}"/>
              </a:ext>
            </a:extLst>
          </p:cNvPr>
          <p:cNvSpPr txBox="1"/>
          <p:nvPr/>
        </p:nvSpPr>
        <p:spPr>
          <a:xfrm rot="19033659">
            <a:off x="3654940" y="1565963"/>
            <a:ext cx="1582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L-FOXO1-KO</a:t>
            </a:r>
          </a:p>
        </p:txBody>
      </p:sp>
      <p:grpSp>
        <p:nvGrpSpPr>
          <p:cNvPr id="22" name="Group 21">
            <a:extLst>
              <a:ext uri="{FF2B5EF4-FFF2-40B4-BE49-F238E27FC236}">
                <a16:creationId xmlns:a16="http://schemas.microsoft.com/office/drawing/2014/main" id="{C8154DDE-6C94-B1C7-B0FE-8BF5097C0469}"/>
              </a:ext>
            </a:extLst>
          </p:cNvPr>
          <p:cNvGrpSpPr/>
          <p:nvPr/>
        </p:nvGrpSpPr>
        <p:grpSpPr>
          <a:xfrm>
            <a:off x="4446182" y="725412"/>
            <a:ext cx="4281219" cy="369332"/>
            <a:chOff x="6592727" y="1885435"/>
            <a:chExt cx="3646100" cy="369332"/>
          </a:xfrm>
        </p:grpSpPr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0BB49961-E24D-BCAF-B673-428585BE77FE}"/>
                </a:ext>
              </a:extLst>
            </p:cNvPr>
            <p:cNvCxnSpPr>
              <a:cxnSpLocks/>
            </p:cNvCxnSpPr>
            <p:nvPr/>
          </p:nvCxnSpPr>
          <p:spPr>
            <a:xfrm>
              <a:off x="6592727" y="2253258"/>
              <a:ext cx="361299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F0486AE8-A58B-8CC0-1EC5-8E96FA4DB46E}"/>
                </a:ext>
              </a:extLst>
            </p:cNvPr>
            <p:cNvSpPr txBox="1"/>
            <p:nvPr/>
          </p:nvSpPr>
          <p:spPr>
            <a:xfrm>
              <a:off x="6625833" y="1885435"/>
              <a:ext cx="36129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Nuclear enrichment</a:t>
              </a:r>
            </a:p>
          </p:txBody>
        </p:sp>
      </p:grpSp>
      <p:sp>
        <p:nvSpPr>
          <p:cNvPr id="41" name="TextBox 40">
            <a:extLst>
              <a:ext uri="{FF2B5EF4-FFF2-40B4-BE49-F238E27FC236}">
                <a16:creationId xmlns:a16="http://schemas.microsoft.com/office/drawing/2014/main" id="{55765EBA-DE52-3847-744F-F1BD0F9BF24B}"/>
              </a:ext>
            </a:extLst>
          </p:cNvPr>
          <p:cNvSpPr txBox="1"/>
          <p:nvPr/>
        </p:nvSpPr>
        <p:spPr>
          <a:xfrm>
            <a:off x="1793189" y="3429000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OXO</a:t>
            </a:r>
          </a:p>
        </p:txBody>
      </p:sp>
      <p:grpSp>
        <p:nvGrpSpPr>
          <p:cNvPr id="59" name="Group 58">
            <a:extLst>
              <a:ext uri="{FF2B5EF4-FFF2-40B4-BE49-F238E27FC236}">
                <a16:creationId xmlns:a16="http://schemas.microsoft.com/office/drawing/2014/main" id="{D4426270-B8D8-45D6-8EBB-4463B9AE23DD}"/>
              </a:ext>
            </a:extLst>
          </p:cNvPr>
          <p:cNvGrpSpPr/>
          <p:nvPr/>
        </p:nvGrpSpPr>
        <p:grpSpPr>
          <a:xfrm>
            <a:off x="7509920" y="1908216"/>
            <a:ext cx="2011680" cy="369332"/>
            <a:chOff x="4259067" y="2088861"/>
            <a:chExt cx="1661336" cy="369332"/>
          </a:xfrm>
        </p:grpSpPr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99329D17-994D-F884-E452-95D92622B260}"/>
                </a:ext>
              </a:extLst>
            </p:cNvPr>
            <p:cNvSpPr txBox="1"/>
            <p:nvPr/>
          </p:nvSpPr>
          <p:spPr>
            <a:xfrm>
              <a:off x="4259067" y="2088861"/>
              <a:ext cx="16613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L-Raptor-KO</a:t>
              </a:r>
            </a:p>
          </p:txBody>
        </p:sp>
        <p:cxnSp>
          <p:nvCxnSpPr>
            <p:cNvPr id="61" name="Straight Connector 60">
              <a:extLst>
                <a:ext uri="{FF2B5EF4-FFF2-40B4-BE49-F238E27FC236}">
                  <a16:creationId xmlns:a16="http://schemas.microsoft.com/office/drawing/2014/main" id="{8A68CAF4-BA67-8119-9AC9-BC90C7189CA2}"/>
                </a:ext>
              </a:extLst>
            </p:cNvPr>
            <p:cNvCxnSpPr>
              <a:cxnSpLocks/>
            </p:cNvCxnSpPr>
            <p:nvPr/>
          </p:nvCxnSpPr>
          <p:spPr>
            <a:xfrm>
              <a:off x="4259067" y="2458193"/>
              <a:ext cx="16613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07E0DFBD-4120-9239-5910-60ABF9AA6F83}"/>
              </a:ext>
            </a:extLst>
          </p:cNvPr>
          <p:cNvGrpSpPr/>
          <p:nvPr/>
        </p:nvGrpSpPr>
        <p:grpSpPr>
          <a:xfrm>
            <a:off x="5281950" y="1908216"/>
            <a:ext cx="2012691" cy="369332"/>
            <a:chOff x="4259067" y="2088861"/>
            <a:chExt cx="1661336" cy="369332"/>
          </a:xfrm>
        </p:grpSpPr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A2C9EBAC-F98A-CC03-2757-E5137C6DBFAF}"/>
                </a:ext>
              </a:extLst>
            </p:cNvPr>
            <p:cNvSpPr txBox="1"/>
            <p:nvPr/>
          </p:nvSpPr>
          <p:spPr>
            <a:xfrm>
              <a:off x="4259067" y="2088861"/>
              <a:ext cx="16613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31D585D7-359E-F740-7F4E-9619588B481D}"/>
                </a:ext>
              </a:extLst>
            </p:cNvPr>
            <p:cNvCxnSpPr>
              <a:cxnSpLocks/>
            </p:cNvCxnSpPr>
            <p:nvPr/>
          </p:nvCxnSpPr>
          <p:spPr>
            <a:xfrm>
              <a:off x="4259067" y="2458193"/>
              <a:ext cx="16613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4" name="TextBox 63">
            <a:extLst>
              <a:ext uri="{FF2B5EF4-FFF2-40B4-BE49-F238E27FC236}">
                <a16:creationId xmlns:a16="http://schemas.microsoft.com/office/drawing/2014/main" id="{93D8787C-1F17-312D-FF27-A34EDF842D76}"/>
              </a:ext>
            </a:extLst>
          </p:cNvPr>
          <p:cNvSpPr txBox="1"/>
          <p:nvPr/>
        </p:nvSpPr>
        <p:spPr>
          <a:xfrm rot="19033659">
            <a:off x="4448366" y="1601784"/>
            <a:ext cx="1505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L-FOXOAAA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9223B8D3-0C0A-C7F6-C9E2-8DF91123208E}"/>
              </a:ext>
            </a:extLst>
          </p:cNvPr>
          <p:cNvSpPr txBox="1"/>
          <p:nvPr/>
        </p:nvSpPr>
        <p:spPr>
          <a:xfrm>
            <a:off x="1425490" y="4366486"/>
            <a:ext cx="942886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p-S6</a:t>
            </a:r>
          </a:p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S240/244)</a:t>
            </a:r>
          </a:p>
        </p:txBody>
      </p: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BC648D89-2D92-0519-1119-8D8706DC3CA5}"/>
              </a:ext>
            </a:extLst>
          </p:cNvPr>
          <p:cNvCxnSpPr>
            <a:cxnSpLocks/>
            <a:endCxn id="13" idx="1"/>
          </p:cNvCxnSpPr>
          <p:nvPr/>
        </p:nvCxnSpPr>
        <p:spPr>
          <a:xfrm flipV="1">
            <a:off x="2556576" y="3574675"/>
            <a:ext cx="1183384" cy="38991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77CF1D46-F55E-0CA4-3F0E-427EE3366232}"/>
              </a:ext>
            </a:extLst>
          </p:cNvPr>
          <p:cNvCxnSpPr>
            <a:cxnSpLocks/>
          </p:cNvCxnSpPr>
          <p:nvPr/>
        </p:nvCxnSpPr>
        <p:spPr>
          <a:xfrm>
            <a:off x="2556576" y="4643485"/>
            <a:ext cx="1183384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Left Bracket 12">
            <a:extLst>
              <a:ext uri="{FF2B5EF4-FFF2-40B4-BE49-F238E27FC236}">
                <a16:creationId xmlns:a16="http://schemas.microsoft.com/office/drawing/2014/main" id="{15271621-A118-8217-5AB0-F4708399C5B0}"/>
              </a:ext>
            </a:extLst>
          </p:cNvPr>
          <p:cNvSpPr/>
          <p:nvPr/>
        </p:nvSpPr>
        <p:spPr>
          <a:xfrm>
            <a:off x="3739960" y="3312376"/>
            <a:ext cx="124724" cy="524597"/>
          </a:xfrm>
          <a:prstGeom prst="leftBracket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992767F-6F24-70F5-8733-0B6489E768F8}"/>
              </a:ext>
            </a:extLst>
          </p:cNvPr>
          <p:cNvSpPr txBox="1"/>
          <p:nvPr/>
        </p:nvSpPr>
        <p:spPr>
          <a:xfrm>
            <a:off x="10994236" y="6488668"/>
            <a:ext cx="1197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5C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1AB0A738-D0C8-61F0-5E6C-94B155A4858B}"/>
              </a:ext>
            </a:extLst>
          </p:cNvPr>
          <p:cNvSpPr/>
          <p:nvPr/>
        </p:nvSpPr>
        <p:spPr>
          <a:xfrm>
            <a:off x="3778480" y="3236979"/>
            <a:ext cx="5856944" cy="821317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E41058B6-D1AD-45EA-3C16-F912949B8EBE}"/>
              </a:ext>
            </a:extLst>
          </p:cNvPr>
          <p:cNvSpPr/>
          <p:nvPr/>
        </p:nvSpPr>
        <p:spPr>
          <a:xfrm>
            <a:off x="3802322" y="4384704"/>
            <a:ext cx="5856944" cy="47736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348249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0" name="Picture 69" descr="A close-up of a test&#10;&#10;Description automatically generated">
            <a:extLst>
              <a:ext uri="{FF2B5EF4-FFF2-40B4-BE49-F238E27FC236}">
                <a16:creationId xmlns:a16="http://schemas.microsoft.com/office/drawing/2014/main" id="{4D5D1DE0-85B0-510C-3364-7DFA66BF4CB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50" t="450" r="404" b="2083"/>
          <a:stretch/>
        </p:blipFill>
        <p:spPr>
          <a:xfrm>
            <a:off x="2784493" y="725412"/>
            <a:ext cx="7908608" cy="4776873"/>
          </a:xfrm>
          <a:prstGeom prst="rect">
            <a:avLst/>
          </a:prstGeom>
          <a:ln>
            <a:noFill/>
          </a:ln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736CC22F-CFAD-DC13-24B8-C51287289EEA}"/>
              </a:ext>
            </a:extLst>
          </p:cNvPr>
          <p:cNvSpPr txBox="1"/>
          <p:nvPr/>
        </p:nvSpPr>
        <p:spPr>
          <a:xfrm rot="19033659">
            <a:off x="3654940" y="1565963"/>
            <a:ext cx="1582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L-FOXO1-KO</a:t>
            </a:r>
          </a:p>
        </p:txBody>
      </p:sp>
      <p:grpSp>
        <p:nvGrpSpPr>
          <p:cNvPr id="22" name="Group 21">
            <a:extLst>
              <a:ext uri="{FF2B5EF4-FFF2-40B4-BE49-F238E27FC236}">
                <a16:creationId xmlns:a16="http://schemas.microsoft.com/office/drawing/2014/main" id="{C8154DDE-6C94-B1C7-B0FE-8BF5097C0469}"/>
              </a:ext>
            </a:extLst>
          </p:cNvPr>
          <p:cNvGrpSpPr/>
          <p:nvPr/>
        </p:nvGrpSpPr>
        <p:grpSpPr>
          <a:xfrm>
            <a:off x="4446182" y="725412"/>
            <a:ext cx="4281219" cy="369332"/>
            <a:chOff x="6592727" y="1885435"/>
            <a:chExt cx="3646100" cy="369332"/>
          </a:xfrm>
        </p:grpSpPr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0BB49961-E24D-BCAF-B673-428585BE77FE}"/>
                </a:ext>
              </a:extLst>
            </p:cNvPr>
            <p:cNvCxnSpPr>
              <a:cxnSpLocks/>
            </p:cNvCxnSpPr>
            <p:nvPr/>
          </p:nvCxnSpPr>
          <p:spPr>
            <a:xfrm>
              <a:off x="6592727" y="2253258"/>
              <a:ext cx="361299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F0486AE8-A58B-8CC0-1EC5-8E96FA4DB46E}"/>
                </a:ext>
              </a:extLst>
            </p:cNvPr>
            <p:cNvSpPr txBox="1"/>
            <p:nvPr/>
          </p:nvSpPr>
          <p:spPr>
            <a:xfrm>
              <a:off x="6625833" y="1885435"/>
              <a:ext cx="36129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Nuclear enrichment</a:t>
              </a:r>
            </a:p>
          </p:txBody>
        </p:sp>
      </p:grpSp>
      <p:grpSp>
        <p:nvGrpSpPr>
          <p:cNvPr id="59" name="Group 58">
            <a:extLst>
              <a:ext uri="{FF2B5EF4-FFF2-40B4-BE49-F238E27FC236}">
                <a16:creationId xmlns:a16="http://schemas.microsoft.com/office/drawing/2014/main" id="{D4426270-B8D8-45D6-8EBB-4463B9AE23DD}"/>
              </a:ext>
            </a:extLst>
          </p:cNvPr>
          <p:cNvGrpSpPr/>
          <p:nvPr/>
        </p:nvGrpSpPr>
        <p:grpSpPr>
          <a:xfrm>
            <a:off x="7509920" y="1908216"/>
            <a:ext cx="2011680" cy="369332"/>
            <a:chOff x="4259067" y="2088861"/>
            <a:chExt cx="1661336" cy="369332"/>
          </a:xfrm>
        </p:grpSpPr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99329D17-994D-F884-E452-95D92622B260}"/>
                </a:ext>
              </a:extLst>
            </p:cNvPr>
            <p:cNvSpPr txBox="1"/>
            <p:nvPr/>
          </p:nvSpPr>
          <p:spPr>
            <a:xfrm>
              <a:off x="4259067" y="2088861"/>
              <a:ext cx="16613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L-Raptor-KO</a:t>
              </a:r>
            </a:p>
          </p:txBody>
        </p:sp>
        <p:cxnSp>
          <p:nvCxnSpPr>
            <p:cNvPr id="61" name="Straight Connector 60">
              <a:extLst>
                <a:ext uri="{FF2B5EF4-FFF2-40B4-BE49-F238E27FC236}">
                  <a16:creationId xmlns:a16="http://schemas.microsoft.com/office/drawing/2014/main" id="{8A68CAF4-BA67-8119-9AC9-BC90C7189CA2}"/>
                </a:ext>
              </a:extLst>
            </p:cNvPr>
            <p:cNvCxnSpPr>
              <a:cxnSpLocks/>
            </p:cNvCxnSpPr>
            <p:nvPr/>
          </p:nvCxnSpPr>
          <p:spPr>
            <a:xfrm>
              <a:off x="4259067" y="2458193"/>
              <a:ext cx="16613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07E0DFBD-4120-9239-5910-60ABF9AA6F83}"/>
              </a:ext>
            </a:extLst>
          </p:cNvPr>
          <p:cNvGrpSpPr/>
          <p:nvPr/>
        </p:nvGrpSpPr>
        <p:grpSpPr>
          <a:xfrm>
            <a:off x="5281950" y="1908216"/>
            <a:ext cx="2012691" cy="369332"/>
            <a:chOff x="4259067" y="2088861"/>
            <a:chExt cx="1661336" cy="369332"/>
          </a:xfrm>
        </p:grpSpPr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A2C9EBAC-F98A-CC03-2757-E5137C6DBFAF}"/>
                </a:ext>
              </a:extLst>
            </p:cNvPr>
            <p:cNvSpPr txBox="1"/>
            <p:nvPr/>
          </p:nvSpPr>
          <p:spPr>
            <a:xfrm>
              <a:off x="4259067" y="2088861"/>
              <a:ext cx="16613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31D585D7-359E-F740-7F4E-9619588B481D}"/>
                </a:ext>
              </a:extLst>
            </p:cNvPr>
            <p:cNvCxnSpPr>
              <a:cxnSpLocks/>
            </p:cNvCxnSpPr>
            <p:nvPr/>
          </p:nvCxnSpPr>
          <p:spPr>
            <a:xfrm>
              <a:off x="4259067" y="2458193"/>
              <a:ext cx="16613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4" name="TextBox 63">
            <a:extLst>
              <a:ext uri="{FF2B5EF4-FFF2-40B4-BE49-F238E27FC236}">
                <a16:creationId xmlns:a16="http://schemas.microsoft.com/office/drawing/2014/main" id="{93D8787C-1F17-312D-FF27-A34EDF842D76}"/>
              </a:ext>
            </a:extLst>
          </p:cNvPr>
          <p:cNvSpPr txBox="1"/>
          <p:nvPr/>
        </p:nvSpPr>
        <p:spPr>
          <a:xfrm rot="19033659">
            <a:off x="4448366" y="1601784"/>
            <a:ext cx="1505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L-FOXOAAA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41AB1FC9-D434-606B-0D00-EA3F22B57927}"/>
              </a:ext>
            </a:extLst>
          </p:cNvPr>
          <p:cNvSpPr txBox="1"/>
          <p:nvPr/>
        </p:nvSpPr>
        <p:spPr>
          <a:xfrm>
            <a:off x="1839963" y="3504304"/>
            <a:ext cx="838691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p-AKT</a:t>
            </a:r>
          </a:p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S473)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1F122B3-2E51-4374-76E0-A6D6F1740FB5}"/>
              </a:ext>
            </a:extLst>
          </p:cNvPr>
          <p:cNvSpPr txBox="1"/>
          <p:nvPr/>
        </p:nvSpPr>
        <p:spPr>
          <a:xfrm>
            <a:off x="10994236" y="6488668"/>
            <a:ext cx="1197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5C</a:t>
            </a:r>
          </a:p>
        </p:txBody>
      </p:sp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94F8B9DD-F9EB-D677-576F-9D42D58C765A}"/>
              </a:ext>
            </a:extLst>
          </p:cNvPr>
          <p:cNvCxnSpPr>
            <a:cxnSpLocks/>
          </p:cNvCxnSpPr>
          <p:nvPr/>
        </p:nvCxnSpPr>
        <p:spPr>
          <a:xfrm>
            <a:off x="2678654" y="3675296"/>
            <a:ext cx="930477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Rectangle 3">
            <a:extLst>
              <a:ext uri="{FF2B5EF4-FFF2-40B4-BE49-F238E27FC236}">
                <a16:creationId xmlns:a16="http://schemas.microsoft.com/office/drawing/2014/main" id="{C423D5CF-2BBB-8DA9-0321-16ECDC67B565}"/>
              </a:ext>
            </a:extLst>
          </p:cNvPr>
          <p:cNvSpPr/>
          <p:nvPr/>
        </p:nvSpPr>
        <p:spPr>
          <a:xfrm>
            <a:off x="3637115" y="3236979"/>
            <a:ext cx="5884485" cy="821317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v</a:t>
            </a:r>
          </a:p>
        </p:txBody>
      </p:sp>
    </p:spTree>
    <p:extLst>
      <p:ext uri="{BB962C8B-B14F-4D97-AF65-F5344CB8AC3E}">
        <p14:creationId xmlns:p14="http://schemas.microsoft.com/office/powerpoint/2010/main" val="25169675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>
            <a:extLst>
              <a:ext uri="{FF2B5EF4-FFF2-40B4-BE49-F238E27FC236}">
                <a16:creationId xmlns:a16="http://schemas.microsoft.com/office/drawing/2014/main" id="{A5F64BCF-B8E5-4744-9062-020AA39FBFE7}"/>
              </a:ext>
            </a:extLst>
          </p:cNvPr>
          <p:cNvSpPr txBox="1"/>
          <p:nvPr/>
        </p:nvSpPr>
        <p:spPr>
          <a:xfrm>
            <a:off x="1260816" y="2868112"/>
            <a:ext cx="1005403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133" dirty="0">
                <a:latin typeface="Arial" panose="020B0604020202020204" pitchFamily="34" charset="0"/>
                <a:cs typeface="Arial" panose="020B0604020202020204" pitchFamily="34" charset="0"/>
              </a:rPr>
              <a:t>Raptor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9D342E4C-B2A9-6045-9248-E3D842460B75}"/>
              </a:ext>
            </a:extLst>
          </p:cNvPr>
          <p:cNvSpPr txBox="1"/>
          <p:nvPr/>
        </p:nvSpPr>
        <p:spPr>
          <a:xfrm>
            <a:off x="3460965" y="1113743"/>
            <a:ext cx="2144680" cy="4205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133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75B1266-5227-3143-BBAA-1D1D5A852079}"/>
              </a:ext>
            </a:extLst>
          </p:cNvPr>
          <p:cNvSpPr txBox="1"/>
          <p:nvPr/>
        </p:nvSpPr>
        <p:spPr>
          <a:xfrm>
            <a:off x="10781284" y="6437436"/>
            <a:ext cx="1385316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Arial" panose="020B0604020202020204" pitchFamily="34" charset="0"/>
                <a:cs typeface="Arial" panose="020B0604020202020204" pitchFamily="34" charset="0"/>
              </a:rPr>
              <a:t>Figure 1D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3535E95D-F3F5-35F3-C9FA-637A388E5E1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45" t="-1552" r="334" b="97"/>
          <a:stretch/>
        </p:blipFill>
        <p:spPr>
          <a:xfrm>
            <a:off x="2501901" y="1595989"/>
            <a:ext cx="8429283" cy="2298673"/>
          </a:xfrm>
          <a:prstGeom prst="rect">
            <a:avLst/>
          </a:prstGeom>
          <a:ln>
            <a:noFill/>
          </a:ln>
        </p:spPr>
      </p:pic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D84494B6-5D5D-925F-710D-78D99374A06E}"/>
              </a:ext>
            </a:extLst>
          </p:cNvPr>
          <p:cNvCxnSpPr>
            <a:cxnSpLocks/>
          </p:cNvCxnSpPr>
          <p:nvPr/>
        </p:nvCxnSpPr>
        <p:spPr>
          <a:xfrm>
            <a:off x="5877973" y="1565148"/>
            <a:ext cx="211259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150D7169-F565-F32A-71BE-2DCD1C60B83C}"/>
              </a:ext>
            </a:extLst>
          </p:cNvPr>
          <p:cNvCxnSpPr>
            <a:cxnSpLocks/>
          </p:cNvCxnSpPr>
          <p:nvPr/>
        </p:nvCxnSpPr>
        <p:spPr>
          <a:xfrm>
            <a:off x="3460964" y="1565148"/>
            <a:ext cx="21446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18D4ECDD-5FB9-A4B1-9217-6EA6C1FBF20C}"/>
              </a:ext>
            </a:extLst>
          </p:cNvPr>
          <p:cNvSpPr txBox="1"/>
          <p:nvPr/>
        </p:nvSpPr>
        <p:spPr>
          <a:xfrm>
            <a:off x="5845890" y="1113744"/>
            <a:ext cx="2144680" cy="4205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133" dirty="0">
                <a:latin typeface="Arial" panose="020B0604020202020204" pitchFamily="34" charset="0"/>
                <a:cs typeface="Arial" panose="020B0604020202020204" pitchFamily="34" charset="0"/>
              </a:rPr>
              <a:t>L-Raptor-KO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D9605D00-D357-58AD-41F8-D19365CA3989}"/>
              </a:ext>
            </a:extLst>
          </p:cNvPr>
          <p:cNvSpPr/>
          <p:nvPr/>
        </p:nvSpPr>
        <p:spPr>
          <a:xfrm>
            <a:off x="3460965" y="2745325"/>
            <a:ext cx="4743236" cy="58317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D999B026-1BF0-8033-2E81-B5AAA1E4CC74}"/>
              </a:ext>
            </a:extLst>
          </p:cNvPr>
          <p:cNvCxnSpPr>
            <a:cxnSpLocks/>
          </p:cNvCxnSpPr>
          <p:nvPr/>
        </p:nvCxnSpPr>
        <p:spPr>
          <a:xfrm>
            <a:off x="2244335" y="3078394"/>
            <a:ext cx="1216629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8508955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TextBox 25">
            <a:extLst>
              <a:ext uri="{FF2B5EF4-FFF2-40B4-BE49-F238E27FC236}">
                <a16:creationId xmlns:a16="http://schemas.microsoft.com/office/drawing/2014/main" id="{9D342E4C-B2A9-6045-9248-E3D842460B75}"/>
              </a:ext>
            </a:extLst>
          </p:cNvPr>
          <p:cNvSpPr txBox="1"/>
          <p:nvPr/>
        </p:nvSpPr>
        <p:spPr>
          <a:xfrm>
            <a:off x="2850543" y="1054812"/>
            <a:ext cx="2144680" cy="4205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133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75B1266-5227-3143-BBAA-1D1D5A852079}"/>
              </a:ext>
            </a:extLst>
          </p:cNvPr>
          <p:cNvSpPr txBox="1"/>
          <p:nvPr/>
        </p:nvSpPr>
        <p:spPr>
          <a:xfrm>
            <a:off x="10781284" y="6437436"/>
            <a:ext cx="1385316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Arial" panose="020B0604020202020204" pitchFamily="34" charset="0"/>
                <a:cs typeface="Arial" panose="020B0604020202020204" pitchFamily="34" charset="0"/>
              </a:rPr>
              <a:t>Figure 1D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976930B-A9CE-5031-C621-C890C2E3B18B}"/>
              </a:ext>
            </a:extLst>
          </p:cNvPr>
          <p:cNvSpPr txBox="1"/>
          <p:nvPr/>
        </p:nvSpPr>
        <p:spPr>
          <a:xfrm>
            <a:off x="459348" y="2085392"/>
            <a:ext cx="1199366" cy="6667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133" dirty="0">
                <a:latin typeface="Arial" panose="020B0604020202020204" pitchFamily="34" charset="0"/>
                <a:cs typeface="Arial" panose="020B0604020202020204" pitchFamily="34" charset="0"/>
              </a:rPr>
              <a:t>p-S6</a:t>
            </a:r>
          </a:p>
          <a:p>
            <a:pPr algn="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(S240/244)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66A29005-CBF9-9BE6-03A9-A318EC7C4D8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09" t="-2053" r="653" b="17052"/>
          <a:stretch/>
        </p:blipFill>
        <p:spPr>
          <a:xfrm>
            <a:off x="2455779" y="1565728"/>
            <a:ext cx="8017726" cy="1706114"/>
          </a:xfrm>
          <a:prstGeom prst="rect">
            <a:avLst/>
          </a:prstGeom>
          <a:ln>
            <a:noFill/>
          </a:ln>
        </p:spPr>
      </p:pic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D84494B6-5D5D-925F-710D-78D99374A06E}"/>
              </a:ext>
            </a:extLst>
          </p:cNvPr>
          <p:cNvCxnSpPr>
            <a:cxnSpLocks/>
          </p:cNvCxnSpPr>
          <p:nvPr/>
        </p:nvCxnSpPr>
        <p:spPr>
          <a:xfrm>
            <a:off x="5479423" y="1506217"/>
            <a:ext cx="211259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150D7169-F565-F32A-71BE-2DCD1C60B83C}"/>
              </a:ext>
            </a:extLst>
          </p:cNvPr>
          <p:cNvCxnSpPr>
            <a:cxnSpLocks/>
          </p:cNvCxnSpPr>
          <p:nvPr/>
        </p:nvCxnSpPr>
        <p:spPr>
          <a:xfrm>
            <a:off x="2850542" y="1506217"/>
            <a:ext cx="21446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18D4ECDD-5FB9-A4B1-9217-6EA6C1FBF20C}"/>
              </a:ext>
            </a:extLst>
          </p:cNvPr>
          <p:cNvSpPr txBox="1"/>
          <p:nvPr/>
        </p:nvSpPr>
        <p:spPr>
          <a:xfrm>
            <a:off x="5447340" y="1054813"/>
            <a:ext cx="2144680" cy="4205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133" dirty="0">
                <a:latin typeface="Arial" panose="020B0604020202020204" pitchFamily="34" charset="0"/>
                <a:cs typeface="Arial" panose="020B0604020202020204" pitchFamily="34" charset="0"/>
              </a:rPr>
              <a:t>L-Raptor-KO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507B54DE-F952-9AB9-B3CC-2DEC9185F2DA}"/>
              </a:ext>
            </a:extLst>
          </p:cNvPr>
          <p:cNvSpPr/>
          <p:nvPr/>
        </p:nvSpPr>
        <p:spPr>
          <a:xfrm>
            <a:off x="2850543" y="2085392"/>
            <a:ext cx="4899556" cy="58317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9D6B4BCE-BEC1-B806-FA26-A3170846FAE7}"/>
              </a:ext>
            </a:extLst>
          </p:cNvPr>
          <p:cNvCxnSpPr>
            <a:cxnSpLocks/>
          </p:cNvCxnSpPr>
          <p:nvPr/>
        </p:nvCxnSpPr>
        <p:spPr>
          <a:xfrm>
            <a:off x="1633913" y="2387019"/>
            <a:ext cx="1216629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4348682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TextBox 25">
            <a:extLst>
              <a:ext uri="{FF2B5EF4-FFF2-40B4-BE49-F238E27FC236}">
                <a16:creationId xmlns:a16="http://schemas.microsoft.com/office/drawing/2014/main" id="{9D342E4C-B2A9-6045-9248-E3D842460B75}"/>
              </a:ext>
            </a:extLst>
          </p:cNvPr>
          <p:cNvSpPr txBox="1"/>
          <p:nvPr/>
        </p:nvSpPr>
        <p:spPr>
          <a:xfrm>
            <a:off x="2995509" y="1051669"/>
            <a:ext cx="2144680" cy="4205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133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75B1266-5227-3143-BBAA-1D1D5A852079}"/>
              </a:ext>
            </a:extLst>
          </p:cNvPr>
          <p:cNvSpPr txBox="1"/>
          <p:nvPr/>
        </p:nvSpPr>
        <p:spPr>
          <a:xfrm>
            <a:off x="10781284" y="6437436"/>
            <a:ext cx="1385316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Arial" panose="020B0604020202020204" pitchFamily="34" charset="0"/>
                <a:cs typeface="Arial" panose="020B0604020202020204" pitchFamily="34" charset="0"/>
              </a:rPr>
              <a:t>Figure 1D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690678A7-ABB7-2B28-AD96-C0492132AB84}"/>
              </a:ext>
            </a:extLst>
          </p:cNvPr>
          <p:cNvSpPr txBox="1"/>
          <p:nvPr/>
        </p:nvSpPr>
        <p:spPr>
          <a:xfrm>
            <a:off x="802921" y="3357730"/>
            <a:ext cx="1051890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133" dirty="0">
                <a:latin typeface="Arial" panose="020B0604020202020204" pitchFamily="34" charset="0"/>
                <a:cs typeface="Arial" panose="020B0604020202020204" pitchFamily="34" charset="0"/>
              </a:rPr>
              <a:t>HSP90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E59F6314-925B-1194-4B61-227663C115B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77" t="251" r="-34" b="4450"/>
          <a:stretch/>
        </p:blipFill>
        <p:spPr>
          <a:xfrm>
            <a:off x="2380756" y="1628080"/>
            <a:ext cx="8207298" cy="3158973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D84494B6-5D5D-925F-710D-78D99374A06E}"/>
              </a:ext>
            </a:extLst>
          </p:cNvPr>
          <p:cNvCxnSpPr>
            <a:cxnSpLocks/>
          </p:cNvCxnSpPr>
          <p:nvPr/>
        </p:nvCxnSpPr>
        <p:spPr>
          <a:xfrm>
            <a:off x="5412517" y="1503074"/>
            <a:ext cx="211259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150D7169-F565-F32A-71BE-2DCD1C60B83C}"/>
              </a:ext>
            </a:extLst>
          </p:cNvPr>
          <p:cNvCxnSpPr>
            <a:cxnSpLocks/>
          </p:cNvCxnSpPr>
          <p:nvPr/>
        </p:nvCxnSpPr>
        <p:spPr>
          <a:xfrm>
            <a:off x="2995508" y="1503074"/>
            <a:ext cx="21446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18D4ECDD-5FB9-A4B1-9217-6EA6C1FBF20C}"/>
              </a:ext>
            </a:extLst>
          </p:cNvPr>
          <p:cNvSpPr txBox="1"/>
          <p:nvPr/>
        </p:nvSpPr>
        <p:spPr>
          <a:xfrm>
            <a:off x="5380434" y="1051670"/>
            <a:ext cx="2144680" cy="4205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133" dirty="0">
                <a:latin typeface="Arial" panose="020B0604020202020204" pitchFamily="34" charset="0"/>
                <a:cs typeface="Arial" panose="020B0604020202020204" pitchFamily="34" charset="0"/>
              </a:rPr>
              <a:t>L-Raptor-KO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C3BC31F6-DFED-0ECE-C284-A54A144C233D}"/>
              </a:ext>
            </a:extLst>
          </p:cNvPr>
          <p:cNvSpPr/>
          <p:nvPr/>
        </p:nvSpPr>
        <p:spPr>
          <a:xfrm>
            <a:off x="2995509" y="3266385"/>
            <a:ext cx="4899556" cy="58317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F1896AFA-C6B8-0F3A-32D2-B516CA74DA1E}"/>
              </a:ext>
            </a:extLst>
          </p:cNvPr>
          <p:cNvCxnSpPr>
            <a:cxnSpLocks/>
          </p:cNvCxnSpPr>
          <p:nvPr/>
        </p:nvCxnSpPr>
        <p:spPr>
          <a:xfrm flipV="1">
            <a:off x="1778879" y="3557974"/>
            <a:ext cx="1163497" cy="10038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9031773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Picture 18" descr="A close-up of a test&#10;&#10;Description automatically generated">
            <a:extLst>
              <a:ext uri="{FF2B5EF4-FFF2-40B4-BE49-F238E27FC236}">
                <a16:creationId xmlns:a16="http://schemas.microsoft.com/office/drawing/2014/main" id="{03A5F216-5E41-E557-3F7B-2D421D84E86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-172" t="17607" r="-96" b="723"/>
          <a:stretch/>
        </p:blipFill>
        <p:spPr>
          <a:xfrm>
            <a:off x="683623" y="1300570"/>
            <a:ext cx="11508377" cy="426589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736CC22F-CFAD-DC13-24B8-C51287289EEA}"/>
              </a:ext>
            </a:extLst>
          </p:cNvPr>
          <p:cNvSpPr txBox="1"/>
          <p:nvPr/>
        </p:nvSpPr>
        <p:spPr>
          <a:xfrm rot="19033659">
            <a:off x="10939150" y="563626"/>
            <a:ext cx="13003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L-GCK-KO</a:t>
            </a:r>
          </a:p>
        </p:txBody>
      </p:sp>
      <p:grpSp>
        <p:nvGrpSpPr>
          <p:cNvPr id="39" name="Group 38">
            <a:extLst>
              <a:ext uri="{FF2B5EF4-FFF2-40B4-BE49-F238E27FC236}">
                <a16:creationId xmlns:a16="http://schemas.microsoft.com/office/drawing/2014/main" id="{26E52161-C3DC-BF96-6AD6-CCCD04FAC12C}"/>
              </a:ext>
            </a:extLst>
          </p:cNvPr>
          <p:cNvGrpSpPr/>
          <p:nvPr/>
        </p:nvGrpSpPr>
        <p:grpSpPr>
          <a:xfrm>
            <a:off x="1736828" y="217436"/>
            <a:ext cx="3612995" cy="370841"/>
            <a:chOff x="2105314" y="853068"/>
            <a:chExt cx="3612995" cy="370841"/>
          </a:xfrm>
        </p:grpSpPr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0D92A6C5-A7EF-F766-4BF4-85DE7F1A67E6}"/>
                </a:ext>
              </a:extLst>
            </p:cNvPr>
            <p:cNvCxnSpPr/>
            <p:nvPr/>
          </p:nvCxnSpPr>
          <p:spPr>
            <a:xfrm>
              <a:off x="2105314" y="1223909"/>
              <a:ext cx="361299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9E76A1CE-876B-FFF4-0A6A-8A23631FBA2D}"/>
                </a:ext>
              </a:extLst>
            </p:cNvPr>
            <p:cNvSpPr txBox="1"/>
            <p:nvPr/>
          </p:nvSpPr>
          <p:spPr>
            <a:xfrm>
              <a:off x="2105314" y="853068"/>
              <a:ext cx="36129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Fasted</a:t>
              </a:r>
            </a:p>
          </p:txBody>
        </p:sp>
      </p:grpSp>
      <p:grpSp>
        <p:nvGrpSpPr>
          <p:cNvPr id="22" name="Group 21">
            <a:extLst>
              <a:ext uri="{FF2B5EF4-FFF2-40B4-BE49-F238E27FC236}">
                <a16:creationId xmlns:a16="http://schemas.microsoft.com/office/drawing/2014/main" id="{C8154DDE-6C94-B1C7-B0FE-8BF5097C0469}"/>
              </a:ext>
            </a:extLst>
          </p:cNvPr>
          <p:cNvGrpSpPr/>
          <p:nvPr/>
        </p:nvGrpSpPr>
        <p:grpSpPr>
          <a:xfrm>
            <a:off x="6786323" y="218945"/>
            <a:ext cx="4281219" cy="369332"/>
            <a:chOff x="6592727" y="1885435"/>
            <a:chExt cx="3646100" cy="369332"/>
          </a:xfrm>
        </p:grpSpPr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0BB49961-E24D-BCAF-B673-428585BE77FE}"/>
                </a:ext>
              </a:extLst>
            </p:cNvPr>
            <p:cNvCxnSpPr>
              <a:cxnSpLocks/>
            </p:cNvCxnSpPr>
            <p:nvPr/>
          </p:nvCxnSpPr>
          <p:spPr>
            <a:xfrm>
              <a:off x="6592727" y="2253258"/>
              <a:ext cx="361299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F0486AE8-A58B-8CC0-1EC5-8E96FA4DB46E}"/>
                </a:ext>
              </a:extLst>
            </p:cNvPr>
            <p:cNvSpPr txBox="1"/>
            <p:nvPr/>
          </p:nvSpPr>
          <p:spPr>
            <a:xfrm>
              <a:off x="6625833" y="1885435"/>
              <a:ext cx="36129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Fed</a:t>
              </a:r>
            </a:p>
          </p:txBody>
        </p:sp>
      </p:grpSp>
      <p:sp>
        <p:nvSpPr>
          <p:cNvPr id="41" name="TextBox 40">
            <a:extLst>
              <a:ext uri="{FF2B5EF4-FFF2-40B4-BE49-F238E27FC236}">
                <a16:creationId xmlns:a16="http://schemas.microsoft.com/office/drawing/2014/main" id="{55765EBA-DE52-3847-744F-F1BD0F9BF24B}"/>
              </a:ext>
            </a:extLst>
          </p:cNvPr>
          <p:cNvSpPr txBox="1"/>
          <p:nvPr/>
        </p:nvSpPr>
        <p:spPr>
          <a:xfrm>
            <a:off x="0" y="3817201"/>
            <a:ext cx="6848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GCK</a:t>
            </a:r>
          </a:p>
        </p:txBody>
      </p:sp>
      <p:grpSp>
        <p:nvGrpSpPr>
          <p:cNvPr id="59" name="Group 58">
            <a:extLst>
              <a:ext uri="{FF2B5EF4-FFF2-40B4-BE49-F238E27FC236}">
                <a16:creationId xmlns:a16="http://schemas.microsoft.com/office/drawing/2014/main" id="{D4426270-B8D8-45D6-8EBB-4463B9AE23DD}"/>
              </a:ext>
            </a:extLst>
          </p:cNvPr>
          <p:cNvGrpSpPr/>
          <p:nvPr/>
        </p:nvGrpSpPr>
        <p:grpSpPr>
          <a:xfrm>
            <a:off x="8780962" y="759758"/>
            <a:ext cx="2011680" cy="369332"/>
            <a:chOff x="4259067" y="2088861"/>
            <a:chExt cx="1661336" cy="369332"/>
          </a:xfrm>
        </p:grpSpPr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99329D17-994D-F884-E452-95D92622B260}"/>
                </a:ext>
              </a:extLst>
            </p:cNvPr>
            <p:cNvSpPr txBox="1"/>
            <p:nvPr/>
          </p:nvSpPr>
          <p:spPr>
            <a:xfrm>
              <a:off x="4259067" y="2088861"/>
              <a:ext cx="16613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L-Raptor-KO</a:t>
              </a:r>
            </a:p>
          </p:txBody>
        </p:sp>
        <p:cxnSp>
          <p:nvCxnSpPr>
            <p:cNvPr id="61" name="Straight Connector 60">
              <a:extLst>
                <a:ext uri="{FF2B5EF4-FFF2-40B4-BE49-F238E27FC236}">
                  <a16:creationId xmlns:a16="http://schemas.microsoft.com/office/drawing/2014/main" id="{8A68CAF4-BA67-8119-9AC9-BC90C7189CA2}"/>
                </a:ext>
              </a:extLst>
            </p:cNvPr>
            <p:cNvCxnSpPr>
              <a:cxnSpLocks/>
            </p:cNvCxnSpPr>
            <p:nvPr/>
          </p:nvCxnSpPr>
          <p:spPr>
            <a:xfrm>
              <a:off x="4259067" y="2458193"/>
              <a:ext cx="16613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07E0DFBD-4120-9239-5910-60ABF9AA6F83}"/>
              </a:ext>
            </a:extLst>
          </p:cNvPr>
          <p:cNvGrpSpPr/>
          <p:nvPr/>
        </p:nvGrpSpPr>
        <p:grpSpPr>
          <a:xfrm>
            <a:off x="6301065" y="759758"/>
            <a:ext cx="2012691" cy="369332"/>
            <a:chOff x="4259067" y="2088861"/>
            <a:chExt cx="1661336" cy="369332"/>
          </a:xfrm>
        </p:grpSpPr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A2C9EBAC-F98A-CC03-2757-E5137C6DBFAF}"/>
                </a:ext>
              </a:extLst>
            </p:cNvPr>
            <p:cNvSpPr txBox="1"/>
            <p:nvPr/>
          </p:nvSpPr>
          <p:spPr>
            <a:xfrm>
              <a:off x="4259067" y="2088861"/>
              <a:ext cx="16613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31D585D7-359E-F740-7F4E-9619588B481D}"/>
                </a:ext>
              </a:extLst>
            </p:cNvPr>
            <p:cNvCxnSpPr>
              <a:cxnSpLocks/>
            </p:cNvCxnSpPr>
            <p:nvPr/>
          </p:nvCxnSpPr>
          <p:spPr>
            <a:xfrm>
              <a:off x="4259067" y="2458193"/>
              <a:ext cx="16613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D0AFA08F-802F-1A09-8A39-53023500505A}"/>
              </a:ext>
            </a:extLst>
          </p:cNvPr>
          <p:cNvGrpSpPr/>
          <p:nvPr/>
        </p:nvGrpSpPr>
        <p:grpSpPr>
          <a:xfrm>
            <a:off x="3776750" y="759758"/>
            <a:ext cx="2011680" cy="369332"/>
            <a:chOff x="4259067" y="2088861"/>
            <a:chExt cx="1661336" cy="369332"/>
          </a:xfrm>
        </p:grpSpPr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EF0DADD5-0075-99F5-5C7A-CA046CD7D3FC}"/>
                </a:ext>
              </a:extLst>
            </p:cNvPr>
            <p:cNvSpPr txBox="1"/>
            <p:nvPr/>
          </p:nvSpPr>
          <p:spPr>
            <a:xfrm>
              <a:off x="4259067" y="2088861"/>
              <a:ext cx="16613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L-Raptor-KO</a:t>
              </a:r>
            </a:p>
          </p:txBody>
        </p: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1C91D279-92D7-2AA5-135C-4F97F0FD7F72}"/>
                </a:ext>
              </a:extLst>
            </p:cNvPr>
            <p:cNvCxnSpPr>
              <a:cxnSpLocks/>
            </p:cNvCxnSpPr>
            <p:nvPr/>
          </p:nvCxnSpPr>
          <p:spPr>
            <a:xfrm>
              <a:off x="4259067" y="2458193"/>
              <a:ext cx="16613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" name="Group 17">
            <a:extLst>
              <a:ext uri="{FF2B5EF4-FFF2-40B4-BE49-F238E27FC236}">
                <a16:creationId xmlns:a16="http://schemas.microsoft.com/office/drawing/2014/main" id="{4B038CB6-8EC8-E154-6B41-ADBF45A29F70}"/>
              </a:ext>
            </a:extLst>
          </p:cNvPr>
          <p:cNvGrpSpPr/>
          <p:nvPr/>
        </p:nvGrpSpPr>
        <p:grpSpPr>
          <a:xfrm>
            <a:off x="1445132" y="759758"/>
            <a:ext cx="2012691" cy="369332"/>
            <a:chOff x="4259067" y="2088861"/>
            <a:chExt cx="1661336" cy="369332"/>
          </a:xfrm>
        </p:grpSpPr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87FE6A94-630C-FE23-741A-AE1454E85780}"/>
                </a:ext>
              </a:extLst>
            </p:cNvPr>
            <p:cNvSpPr txBox="1"/>
            <p:nvPr/>
          </p:nvSpPr>
          <p:spPr>
            <a:xfrm>
              <a:off x="4259067" y="2088861"/>
              <a:ext cx="16613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E9C0FE81-F752-BF54-038F-B5FDEA75752E}"/>
                </a:ext>
              </a:extLst>
            </p:cNvPr>
            <p:cNvCxnSpPr>
              <a:cxnSpLocks/>
            </p:cNvCxnSpPr>
            <p:nvPr/>
          </p:nvCxnSpPr>
          <p:spPr>
            <a:xfrm>
              <a:off x="4259067" y="2458193"/>
              <a:ext cx="16613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7E05DB59-966F-4989-93C7-FF6D8C89E132}"/>
              </a:ext>
            </a:extLst>
          </p:cNvPr>
          <p:cNvSpPr txBox="1"/>
          <p:nvPr/>
        </p:nvSpPr>
        <p:spPr>
          <a:xfrm>
            <a:off x="10994236" y="6488668"/>
            <a:ext cx="1197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2C</a:t>
            </a:r>
          </a:p>
        </p:txBody>
      </p:sp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C6E08C1C-C5F9-6D00-EC5C-275C3F74093F}"/>
              </a:ext>
            </a:extLst>
          </p:cNvPr>
          <p:cNvCxnSpPr>
            <a:cxnSpLocks/>
          </p:cNvCxnSpPr>
          <p:nvPr/>
        </p:nvCxnSpPr>
        <p:spPr>
          <a:xfrm>
            <a:off x="683622" y="4001867"/>
            <a:ext cx="1005693" cy="48357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Rectangle 10">
            <a:extLst>
              <a:ext uri="{FF2B5EF4-FFF2-40B4-BE49-F238E27FC236}">
                <a16:creationId xmlns:a16="http://schemas.microsoft.com/office/drawing/2014/main" id="{7C93D4AE-86AA-02B1-ADF2-96011EA63E2F}"/>
              </a:ext>
            </a:extLst>
          </p:cNvPr>
          <p:cNvSpPr/>
          <p:nvPr/>
        </p:nvSpPr>
        <p:spPr>
          <a:xfrm>
            <a:off x="1689315" y="3714501"/>
            <a:ext cx="10015005" cy="58317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619527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TextBox 33">
            <a:extLst>
              <a:ext uri="{FF2B5EF4-FFF2-40B4-BE49-F238E27FC236}">
                <a16:creationId xmlns:a16="http://schemas.microsoft.com/office/drawing/2014/main" id="{141A44A0-1028-43A0-31AF-508A0365573B}"/>
              </a:ext>
            </a:extLst>
          </p:cNvPr>
          <p:cNvSpPr txBox="1"/>
          <p:nvPr/>
        </p:nvSpPr>
        <p:spPr>
          <a:xfrm>
            <a:off x="504482" y="3433021"/>
            <a:ext cx="838691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p-AKT</a:t>
            </a:r>
          </a:p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S473)</a:t>
            </a:r>
          </a:p>
        </p:txBody>
      </p:sp>
      <p:pic>
        <p:nvPicPr>
          <p:cNvPr id="24" name="Picture 23" descr="A black and white photo of a line&#10;&#10;Description automatically generated">
            <a:extLst>
              <a:ext uri="{FF2B5EF4-FFF2-40B4-BE49-F238E27FC236}">
                <a16:creationId xmlns:a16="http://schemas.microsoft.com/office/drawing/2014/main" id="{45988D6E-2132-7260-6ED0-534CBCFA107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21" t="-964" r="464" b="4796"/>
          <a:stretch/>
        </p:blipFill>
        <p:spPr>
          <a:xfrm>
            <a:off x="1754580" y="1129090"/>
            <a:ext cx="9771018" cy="5437472"/>
          </a:xfrm>
          <a:prstGeom prst="rect">
            <a:avLst/>
          </a:prstGeom>
          <a:ln>
            <a:noFill/>
          </a:ln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7E05DB59-966F-4989-93C7-FF6D8C89E132}"/>
              </a:ext>
            </a:extLst>
          </p:cNvPr>
          <p:cNvSpPr txBox="1"/>
          <p:nvPr/>
        </p:nvSpPr>
        <p:spPr>
          <a:xfrm>
            <a:off x="10994236" y="6488668"/>
            <a:ext cx="1197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2C</a:t>
            </a:r>
          </a:p>
        </p:txBody>
      </p: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212F63E3-397E-678C-43F5-03DBDB794009}"/>
              </a:ext>
            </a:extLst>
          </p:cNvPr>
          <p:cNvCxnSpPr>
            <a:cxnSpLocks/>
          </p:cNvCxnSpPr>
          <p:nvPr/>
        </p:nvCxnSpPr>
        <p:spPr>
          <a:xfrm>
            <a:off x="1343173" y="3661663"/>
            <a:ext cx="1005693" cy="48357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Rectangle 4">
            <a:extLst>
              <a:ext uri="{FF2B5EF4-FFF2-40B4-BE49-F238E27FC236}">
                <a16:creationId xmlns:a16="http://schemas.microsoft.com/office/drawing/2014/main" id="{79FEEBC6-705D-9085-2B3D-B33F8EDFBB9C}"/>
              </a:ext>
            </a:extLst>
          </p:cNvPr>
          <p:cNvSpPr/>
          <p:nvPr/>
        </p:nvSpPr>
        <p:spPr>
          <a:xfrm>
            <a:off x="2348866" y="3429170"/>
            <a:ext cx="8645370" cy="557850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45BF722-421E-E8BF-C7D6-617EF57E5DA9}"/>
              </a:ext>
            </a:extLst>
          </p:cNvPr>
          <p:cNvSpPr txBox="1"/>
          <p:nvPr/>
        </p:nvSpPr>
        <p:spPr>
          <a:xfrm rot="19033659">
            <a:off x="10417364" y="505624"/>
            <a:ext cx="13003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L-GCK-KO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84B8E1B7-46AD-5007-5902-C572B14D65CD}"/>
              </a:ext>
            </a:extLst>
          </p:cNvPr>
          <p:cNvGrpSpPr/>
          <p:nvPr/>
        </p:nvGrpSpPr>
        <p:grpSpPr>
          <a:xfrm>
            <a:off x="2730393" y="217436"/>
            <a:ext cx="2619430" cy="370841"/>
            <a:chOff x="2105314" y="853068"/>
            <a:chExt cx="3612995" cy="370841"/>
          </a:xfrm>
        </p:grpSpPr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01F8A10E-28FA-72B0-DD58-632967874A67}"/>
                </a:ext>
              </a:extLst>
            </p:cNvPr>
            <p:cNvCxnSpPr/>
            <p:nvPr/>
          </p:nvCxnSpPr>
          <p:spPr>
            <a:xfrm>
              <a:off x="2105314" y="1223909"/>
              <a:ext cx="361299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5B569A3B-3424-24DF-AF2E-AE830BCB6E7F}"/>
                </a:ext>
              </a:extLst>
            </p:cNvPr>
            <p:cNvSpPr txBox="1"/>
            <p:nvPr/>
          </p:nvSpPr>
          <p:spPr>
            <a:xfrm>
              <a:off x="2105314" y="853068"/>
              <a:ext cx="361299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Fasted</a:t>
              </a:r>
            </a:p>
          </p:txBody>
        </p:sp>
      </p:grpSp>
      <p:grpSp>
        <p:nvGrpSpPr>
          <p:cNvPr id="23" name="Group 22">
            <a:extLst>
              <a:ext uri="{FF2B5EF4-FFF2-40B4-BE49-F238E27FC236}">
                <a16:creationId xmlns:a16="http://schemas.microsoft.com/office/drawing/2014/main" id="{BA433A76-9928-626D-E510-C1A790DC24CD}"/>
              </a:ext>
            </a:extLst>
          </p:cNvPr>
          <p:cNvGrpSpPr/>
          <p:nvPr/>
        </p:nvGrpSpPr>
        <p:grpSpPr>
          <a:xfrm>
            <a:off x="7963648" y="218945"/>
            <a:ext cx="3030588" cy="367823"/>
            <a:chOff x="6592727" y="1885435"/>
            <a:chExt cx="3646100" cy="367823"/>
          </a:xfrm>
        </p:grpSpPr>
        <p:cxnSp>
          <p:nvCxnSpPr>
            <p:cNvPr id="25" name="Straight Connector 24">
              <a:extLst>
                <a:ext uri="{FF2B5EF4-FFF2-40B4-BE49-F238E27FC236}">
                  <a16:creationId xmlns:a16="http://schemas.microsoft.com/office/drawing/2014/main" id="{6C7A5946-9F9F-0402-D46B-F7EB49E26FDA}"/>
                </a:ext>
              </a:extLst>
            </p:cNvPr>
            <p:cNvCxnSpPr>
              <a:cxnSpLocks/>
            </p:cNvCxnSpPr>
            <p:nvPr/>
          </p:nvCxnSpPr>
          <p:spPr>
            <a:xfrm>
              <a:off x="6592727" y="2253258"/>
              <a:ext cx="361299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8C47247E-9C2E-3880-7EB3-C5F06F73C27B}"/>
                </a:ext>
              </a:extLst>
            </p:cNvPr>
            <p:cNvSpPr txBox="1"/>
            <p:nvPr/>
          </p:nvSpPr>
          <p:spPr>
            <a:xfrm>
              <a:off x="6625833" y="1885435"/>
              <a:ext cx="361299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Fed</a:t>
              </a:r>
            </a:p>
          </p:txBody>
        </p:sp>
      </p:grpSp>
      <p:grpSp>
        <p:nvGrpSpPr>
          <p:cNvPr id="27" name="Group 26">
            <a:extLst>
              <a:ext uri="{FF2B5EF4-FFF2-40B4-BE49-F238E27FC236}">
                <a16:creationId xmlns:a16="http://schemas.microsoft.com/office/drawing/2014/main" id="{F44883BB-A19B-7934-F9C8-81809F0F377F}"/>
              </a:ext>
            </a:extLst>
          </p:cNvPr>
          <p:cNvGrpSpPr/>
          <p:nvPr/>
        </p:nvGrpSpPr>
        <p:grpSpPr>
          <a:xfrm>
            <a:off x="8544241" y="690289"/>
            <a:ext cx="1458473" cy="369332"/>
            <a:chOff x="4259067" y="2088861"/>
            <a:chExt cx="1661336" cy="369332"/>
          </a:xfrm>
        </p:grpSpPr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61988AC6-D564-2818-3482-6905240BDA89}"/>
                </a:ext>
              </a:extLst>
            </p:cNvPr>
            <p:cNvSpPr txBox="1"/>
            <p:nvPr/>
          </p:nvSpPr>
          <p:spPr>
            <a:xfrm>
              <a:off x="4259067" y="2088861"/>
              <a:ext cx="166133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L-Raptor-KO</a:t>
              </a:r>
            </a:p>
          </p:txBody>
        </p:sp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86255413-8ECC-6534-B5AA-88F11646DA34}"/>
                </a:ext>
              </a:extLst>
            </p:cNvPr>
            <p:cNvCxnSpPr>
              <a:cxnSpLocks/>
            </p:cNvCxnSpPr>
            <p:nvPr/>
          </p:nvCxnSpPr>
          <p:spPr>
            <a:xfrm>
              <a:off x="4259067" y="2458193"/>
              <a:ext cx="16613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1" name="Group 30">
            <a:extLst>
              <a:ext uri="{FF2B5EF4-FFF2-40B4-BE49-F238E27FC236}">
                <a16:creationId xmlns:a16="http://schemas.microsoft.com/office/drawing/2014/main" id="{2990ED15-BA6C-93E7-A1E0-917190685772}"/>
              </a:ext>
            </a:extLst>
          </p:cNvPr>
          <p:cNvGrpSpPr/>
          <p:nvPr/>
        </p:nvGrpSpPr>
        <p:grpSpPr>
          <a:xfrm>
            <a:off x="6624116" y="726910"/>
            <a:ext cx="1459206" cy="369332"/>
            <a:chOff x="4259067" y="2088861"/>
            <a:chExt cx="1661336" cy="369332"/>
          </a:xfrm>
        </p:grpSpPr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20AE3E1D-2176-CFE7-4D23-9583738C5155}"/>
                </a:ext>
              </a:extLst>
            </p:cNvPr>
            <p:cNvSpPr txBox="1"/>
            <p:nvPr/>
          </p:nvSpPr>
          <p:spPr>
            <a:xfrm>
              <a:off x="4259067" y="2088861"/>
              <a:ext cx="166133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cxnSp>
          <p:nvCxnSpPr>
            <p:cNvPr id="40" name="Straight Connector 39">
              <a:extLst>
                <a:ext uri="{FF2B5EF4-FFF2-40B4-BE49-F238E27FC236}">
                  <a16:creationId xmlns:a16="http://schemas.microsoft.com/office/drawing/2014/main" id="{94F78D48-AED9-257C-F66D-C63759746AD5}"/>
                </a:ext>
              </a:extLst>
            </p:cNvPr>
            <p:cNvCxnSpPr>
              <a:cxnSpLocks/>
            </p:cNvCxnSpPr>
            <p:nvPr/>
          </p:nvCxnSpPr>
          <p:spPr>
            <a:xfrm>
              <a:off x="4259067" y="2458193"/>
              <a:ext cx="16613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2" name="Group 41">
            <a:extLst>
              <a:ext uri="{FF2B5EF4-FFF2-40B4-BE49-F238E27FC236}">
                <a16:creationId xmlns:a16="http://schemas.microsoft.com/office/drawing/2014/main" id="{488B44D1-0F44-5A83-83BC-6BCE8B3D9189}"/>
              </a:ext>
            </a:extLst>
          </p:cNvPr>
          <p:cNvGrpSpPr/>
          <p:nvPr/>
        </p:nvGrpSpPr>
        <p:grpSpPr>
          <a:xfrm>
            <a:off x="4651251" y="721085"/>
            <a:ext cx="1458473" cy="369332"/>
            <a:chOff x="4259067" y="2088861"/>
            <a:chExt cx="1661336" cy="369332"/>
          </a:xfrm>
        </p:grpSpPr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66890362-517A-6C65-E618-C700823FA131}"/>
                </a:ext>
              </a:extLst>
            </p:cNvPr>
            <p:cNvSpPr txBox="1"/>
            <p:nvPr/>
          </p:nvSpPr>
          <p:spPr>
            <a:xfrm>
              <a:off x="4259067" y="2088861"/>
              <a:ext cx="166133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L-Raptor-KO</a:t>
              </a:r>
            </a:p>
          </p:txBody>
        </p:sp>
        <p:cxnSp>
          <p:nvCxnSpPr>
            <p:cNvPr id="44" name="Straight Connector 43">
              <a:extLst>
                <a:ext uri="{FF2B5EF4-FFF2-40B4-BE49-F238E27FC236}">
                  <a16:creationId xmlns:a16="http://schemas.microsoft.com/office/drawing/2014/main" id="{7209BA23-28BD-4276-6FDF-A4D4BDA83827}"/>
                </a:ext>
              </a:extLst>
            </p:cNvPr>
            <p:cNvCxnSpPr>
              <a:cxnSpLocks/>
            </p:cNvCxnSpPr>
            <p:nvPr/>
          </p:nvCxnSpPr>
          <p:spPr>
            <a:xfrm>
              <a:off x="4259067" y="2458193"/>
              <a:ext cx="16613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5" name="Group 44">
            <a:extLst>
              <a:ext uri="{FF2B5EF4-FFF2-40B4-BE49-F238E27FC236}">
                <a16:creationId xmlns:a16="http://schemas.microsoft.com/office/drawing/2014/main" id="{510CE898-D1D0-3AB4-ABC5-52D64B11E446}"/>
              </a:ext>
            </a:extLst>
          </p:cNvPr>
          <p:cNvGrpSpPr/>
          <p:nvPr/>
        </p:nvGrpSpPr>
        <p:grpSpPr>
          <a:xfrm>
            <a:off x="2730393" y="739392"/>
            <a:ext cx="1459206" cy="369332"/>
            <a:chOff x="4259067" y="2088861"/>
            <a:chExt cx="1661336" cy="369332"/>
          </a:xfrm>
        </p:grpSpPr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83E45647-805E-DF9D-532D-47AAB99240FB}"/>
                </a:ext>
              </a:extLst>
            </p:cNvPr>
            <p:cNvSpPr txBox="1"/>
            <p:nvPr/>
          </p:nvSpPr>
          <p:spPr>
            <a:xfrm>
              <a:off x="4259067" y="2088861"/>
              <a:ext cx="166133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id="{094E3280-B6BD-2D02-8D3F-3E3AA32BAC53}"/>
                </a:ext>
              </a:extLst>
            </p:cNvPr>
            <p:cNvCxnSpPr>
              <a:cxnSpLocks/>
            </p:cNvCxnSpPr>
            <p:nvPr/>
          </p:nvCxnSpPr>
          <p:spPr>
            <a:xfrm>
              <a:off x="4259067" y="2458193"/>
              <a:ext cx="16613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30304217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 descr="A black and white photo of a grid&#10;&#10;Description automatically generated">
            <a:extLst>
              <a:ext uri="{FF2B5EF4-FFF2-40B4-BE49-F238E27FC236}">
                <a16:creationId xmlns:a16="http://schemas.microsoft.com/office/drawing/2014/main" id="{81CAA5D7-7932-DDF5-0D5D-F5404D21875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28" t="-2046" r="490" b="1150"/>
          <a:stretch/>
        </p:blipFill>
        <p:spPr>
          <a:xfrm>
            <a:off x="174895" y="444332"/>
            <a:ext cx="11922139" cy="6044336"/>
          </a:xfrm>
          <a:prstGeom prst="rect">
            <a:avLst/>
          </a:prstGeom>
          <a:ln>
            <a:noFill/>
          </a:ln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736CC22F-CFAD-DC13-24B8-C51287289EEA}"/>
              </a:ext>
            </a:extLst>
          </p:cNvPr>
          <p:cNvSpPr txBox="1"/>
          <p:nvPr/>
        </p:nvSpPr>
        <p:spPr>
          <a:xfrm rot="19033659">
            <a:off x="10774050" y="970026"/>
            <a:ext cx="13003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L-GCK-KO</a:t>
            </a:r>
          </a:p>
        </p:txBody>
      </p:sp>
      <p:grpSp>
        <p:nvGrpSpPr>
          <p:cNvPr id="39" name="Group 38">
            <a:extLst>
              <a:ext uri="{FF2B5EF4-FFF2-40B4-BE49-F238E27FC236}">
                <a16:creationId xmlns:a16="http://schemas.microsoft.com/office/drawing/2014/main" id="{26E52161-C3DC-BF96-6AD6-CCCD04FAC12C}"/>
              </a:ext>
            </a:extLst>
          </p:cNvPr>
          <p:cNvGrpSpPr/>
          <p:nvPr/>
        </p:nvGrpSpPr>
        <p:grpSpPr>
          <a:xfrm>
            <a:off x="1571728" y="39636"/>
            <a:ext cx="3612995" cy="370841"/>
            <a:chOff x="2105314" y="853068"/>
            <a:chExt cx="3612995" cy="370841"/>
          </a:xfrm>
        </p:grpSpPr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0D92A6C5-A7EF-F766-4BF4-85DE7F1A67E6}"/>
                </a:ext>
              </a:extLst>
            </p:cNvPr>
            <p:cNvCxnSpPr/>
            <p:nvPr/>
          </p:nvCxnSpPr>
          <p:spPr>
            <a:xfrm>
              <a:off x="2105314" y="1223909"/>
              <a:ext cx="361299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9E76A1CE-876B-FFF4-0A6A-8A23631FBA2D}"/>
                </a:ext>
              </a:extLst>
            </p:cNvPr>
            <p:cNvSpPr txBox="1"/>
            <p:nvPr/>
          </p:nvSpPr>
          <p:spPr>
            <a:xfrm>
              <a:off x="2105314" y="853068"/>
              <a:ext cx="36129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Fasted</a:t>
              </a:r>
            </a:p>
          </p:txBody>
        </p:sp>
      </p:grpSp>
      <p:grpSp>
        <p:nvGrpSpPr>
          <p:cNvPr id="22" name="Group 21">
            <a:extLst>
              <a:ext uri="{FF2B5EF4-FFF2-40B4-BE49-F238E27FC236}">
                <a16:creationId xmlns:a16="http://schemas.microsoft.com/office/drawing/2014/main" id="{C8154DDE-6C94-B1C7-B0FE-8BF5097C0469}"/>
              </a:ext>
            </a:extLst>
          </p:cNvPr>
          <p:cNvGrpSpPr/>
          <p:nvPr/>
        </p:nvGrpSpPr>
        <p:grpSpPr>
          <a:xfrm>
            <a:off x="6621223" y="41145"/>
            <a:ext cx="4281219" cy="369332"/>
            <a:chOff x="6592727" y="1885435"/>
            <a:chExt cx="3646100" cy="369332"/>
          </a:xfrm>
        </p:grpSpPr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0BB49961-E24D-BCAF-B673-428585BE77FE}"/>
                </a:ext>
              </a:extLst>
            </p:cNvPr>
            <p:cNvCxnSpPr>
              <a:cxnSpLocks/>
            </p:cNvCxnSpPr>
            <p:nvPr/>
          </p:nvCxnSpPr>
          <p:spPr>
            <a:xfrm>
              <a:off x="6592727" y="2253258"/>
              <a:ext cx="361299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F0486AE8-A58B-8CC0-1EC5-8E96FA4DB46E}"/>
                </a:ext>
              </a:extLst>
            </p:cNvPr>
            <p:cNvSpPr txBox="1"/>
            <p:nvPr/>
          </p:nvSpPr>
          <p:spPr>
            <a:xfrm>
              <a:off x="6625833" y="1885435"/>
              <a:ext cx="36129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Fed</a:t>
              </a:r>
            </a:p>
          </p:txBody>
        </p:sp>
      </p:grpSp>
      <p:grpSp>
        <p:nvGrpSpPr>
          <p:cNvPr id="59" name="Group 58">
            <a:extLst>
              <a:ext uri="{FF2B5EF4-FFF2-40B4-BE49-F238E27FC236}">
                <a16:creationId xmlns:a16="http://schemas.microsoft.com/office/drawing/2014/main" id="{D4426270-B8D8-45D6-8EBB-4463B9AE23DD}"/>
              </a:ext>
            </a:extLst>
          </p:cNvPr>
          <p:cNvGrpSpPr/>
          <p:nvPr/>
        </p:nvGrpSpPr>
        <p:grpSpPr>
          <a:xfrm>
            <a:off x="8615862" y="1166158"/>
            <a:ext cx="2011680" cy="369332"/>
            <a:chOff x="4259067" y="2088861"/>
            <a:chExt cx="1661336" cy="369332"/>
          </a:xfrm>
        </p:grpSpPr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99329D17-994D-F884-E452-95D92622B260}"/>
                </a:ext>
              </a:extLst>
            </p:cNvPr>
            <p:cNvSpPr txBox="1"/>
            <p:nvPr/>
          </p:nvSpPr>
          <p:spPr>
            <a:xfrm>
              <a:off x="4259067" y="2088861"/>
              <a:ext cx="16613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L-Raptor-KO</a:t>
              </a:r>
            </a:p>
          </p:txBody>
        </p:sp>
        <p:cxnSp>
          <p:nvCxnSpPr>
            <p:cNvPr id="61" name="Straight Connector 60">
              <a:extLst>
                <a:ext uri="{FF2B5EF4-FFF2-40B4-BE49-F238E27FC236}">
                  <a16:creationId xmlns:a16="http://schemas.microsoft.com/office/drawing/2014/main" id="{8A68CAF4-BA67-8119-9AC9-BC90C7189CA2}"/>
                </a:ext>
              </a:extLst>
            </p:cNvPr>
            <p:cNvCxnSpPr>
              <a:cxnSpLocks/>
            </p:cNvCxnSpPr>
            <p:nvPr/>
          </p:nvCxnSpPr>
          <p:spPr>
            <a:xfrm>
              <a:off x="4259067" y="2458193"/>
              <a:ext cx="16613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07E0DFBD-4120-9239-5910-60ABF9AA6F83}"/>
              </a:ext>
            </a:extLst>
          </p:cNvPr>
          <p:cNvGrpSpPr/>
          <p:nvPr/>
        </p:nvGrpSpPr>
        <p:grpSpPr>
          <a:xfrm>
            <a:off x="6135965" y="1166158"/>
            <a:ext cx="2012691" cy="369332"/>
            <a:chOff x="4259067" y="2088861"/>
            <a:chExt cx="1661336" cy="369332"/>
          </a:xfrm>
        </p:grpSpPr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A2C9EBAC-F98A-CC03-2757-E5137C6DBFAF}"/>
                </a:ext>
              </a:extLst>
            </p:cNvPr>
            <p:cNvSpPr txBox="1"/>
            <p:nvPr/>
          </p:nvSpPr>
          <p:spPr>
            <a:xfrm>
              <a:off x="4259067" y="2088861"/>
              <a:ext cx="16613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31D585D7-359E-F740-7F4E-9619588B481D}"/>
                </a:ext>
              </a:extLst>
            </p:cNvPr>
            <p:cNvCxnSpPr>
              <a:cxnSpLocks/>
            </p:cNvCxnSpPr>
            <p:nvPr/>
          </p:nvCxnSpPr>
          <p:spPr>
            <a:xfrm>
              <a:off x="4259067" y="2458193"/>
              <a:ext cx="16613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D0AFA08F-802F-1A09-8A39-53023500505A}"/>
              </a:ext>
            </a:extLst>
          </p:cNvPr>
          <p:cNvGrpSpPr/>
          <p:nvPr/>
        </p:nvGrpSpPr>
        <p:grpSpPr>
          <a:xfrm>
            <a:off x="3611650" y="1166158"/>
            <a:ext cx="2011680" cy="369332"/>
            <a:chOff x="4259067" y="2088861"/>
            <a:chExt cx="1661336" cy="369332"/>
          </a:xfrm>
        </p:grpSpPr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EF0DADD5-0075-99F5-5C7A-CA046CD7D3FC}"/>
                </a:ext>
              </a:extLst>
            </p:cNvPr>
            <p:cNvSpPr txBox="1"/>
            <p:nvPr/>
          </p:nvSpPr>
          <p:spPr>
            <a:xfrm>
              <a:off x="4259067" y="2088861"/>
              <a:ext cx="16613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L-Raptor-KO</a:t>
              </a:r>
            </a:p>
          </p:txBody>
        </p: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1C91D279-92D7-2AA5-135C-4F97F0FD7F72}"/>
                </a:ext>
              </a:extLst>
            </p:cNvPr>
            <p:cNvCxnSpPr>
              <a:cxnSpLocks/>
            </p:cNvCxnSpPr>
            <p:nvPr/>
          </p:nvCxnSpPr>
          <p:spPr>
            <a:xfrm>
              <a:off x="4259067" y="2458193"/>
              <a:ext cx="16613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" name="Group 17">
            <a:extLst>
              <a:ext uri="{FF2B5EF4-FFF2-40B4-BE49-F238E27FC236}">
                <a16:creationId xmlns:a16="http://schemas.microsoft.com/office/drawing/2014/main" id="{4B038CB6-8EC8-E154-6B41-ADBF45A29F70}"/>
              </a:ext>
            </a:extLst>
          </p:cNvPr>
          <p:cNvGrpSpPr/>
          <p:nvPr/>
        </p:nvGrpSpPr>
        <p:grpSpPr>
          <a:xfrm>
            <a:off x="1280032" y="1166158"/>
            <a:ext cx="2012691" cy="369332"/>
            <a:chOff x="4259067" y="2088861"/>
            <a:chExt cx="1661336" cy="369332"/>
          </a:xfrm>
        </p:grpSpPr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87FE6A94-630C-FE23-741A-AE1454E85780}"/>
                </a:ext>
              </a:extLst>
            </p:cNvPr>
            <p:cNvSpPr txBox="1"/>
            <p:nvPr/>
          </p:nvSpPr>
          <p:spPr>
            <a:xfrm>
              <a:off x="4259067" y="2088861"/>
              <a:ext cx="16613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E9C0FE81-F752-BF54-038F-B5FDEA75752E}"/>
                </a:ext>
              </a:extLst>
            </p:cNvPr>
            <p:cNvCxnSpPr>
              <a:cxnSpLocks/>
            </p:cNvCxnSpPr>
            <p:nvPr/>
          </p:nvCxnSpPr>
          <p:spPr>
            <a:xfrm>
              <a:off x="4259067" y="2458193"/>
              <a:ext cx="16613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0" name="TextBox 29">
            <a:extLst>
              <a:ext uri="{FF2B5EF4-FFF2-40B4-BE49-F238E27FC236}">
                <a16:creationId xmlns:a16="http://schemas.microsoft.com/office/drawing/2014/main" id="{44B716B8-2AC8-0DC2-CAD5-16E097CA738E}"/>
              </a:ext>
            </a:extLst>
          </p:cNvPr>
          <p:cNvSpPr txBox="1"/>
          <p:nvPr/>
        </p:nvSpPr>
        <p:spPr>
          <a:xfrm>
            <a:off x="174895" y="5199857"/>
            <a:ext cx="942886" cy="55399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p-S6</a:t>
            </a:r>
          </a:p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S240/244)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7F7D6916-C25B-2AFB-61AC-F11BAC299D07}"/>
              </a:ext>
            </a:extLst>
          </p:cNvPr>
          <p:cNvSpPr txBox="1"/>
          <p:nvPr/>
        </p:nvSpPr>
        <p:spPr>
          <a:xfrm>
            <a:off x="-48453" y="3244334"/>
            <a:ext cx="915635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HSP90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E05DB59-966F-4989-93C7-FF6D8C89E132}"/>
              </a:ext>
            </a:extLst>
          </p:cNvPr>
          <p:cNvSpPr txBox="1"/>
          <p:nvPr/>
        </p:nvSpPr>
        <p:spPr>
          <a:xfrm>
            <a:off x="10994236" y="6488668"/>
            <a:ext cx="1197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2C</a:t>
            </a:r>
          </a:p>
        </p:txBody>
      </p:sp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9C4B0B8F-E275-F5AF-7EBC-F86ACEE9BAD4}"/>
              </a:ext>
            </a:extLst>
          </p:cNvPr>
          <p:cNvCxnSpPr>
            <a:cxnSpLocks/>
          </p:cNvCxnSpPr>
          <p:nvPr/>
        </p:nvCxnSpPr>
        <p:spPr>
          <a:xfrm flipV="1">
            <a:off x="777185" y="3386770"/>
            <a:ext cx="657915" cy="126014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B388360D-F62D-827D-023C-EBE19A02A147}"/>
              </a:ext>
            </a:extLst>
          </p:cNvPr>
          <p:cNvCxnSpPr>
            <a:cxnSpLocks/>
          </p:cNvCxnSpPr>
          <p:nvPr/>
        </p:nvCxnSpPr>
        <p:spPr>
          <a:xfrm flipV="1">
            <a:off x="1012171" y="5372100"/>
            <a:ext cx="328958" cy="10475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Rectangle 7">
            <a:extLst>
              <a:ext uri="{FF2B5EF4-FFF2-40B4-BE49-F238E27FC236}">
                <a16:creationId xmlns:a16="http://schemas.microsoft.com/office/drawing/2014/main" id="{517B5DDD-33A5-08A0-1DD1-FFDE8CC48A71}"/>
              </a:ext>
            </a:extLst>
          </p:cNvPr>
          <p:cNvSpPr/>
          <p:nvPr/>
        </p:nvSpPr>
        <p:spPr>
          <a:xfrm>
            <a:off x="1435099" y="3107845"/>
            <a:ext cx="10251805" cy="557850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187CB4B1-2A6D-8486-3633-6C61D28C74EB}"/>
              </a:ext>
            </a:extLst>
          </p:cNvPr>
          <p:cNvSpPr/>
          <p:nvPr/>
        </p:nvSpPr>
        <p:spPr>
          <a:xfrm>
            <a:off x="1435098" y="5145553"/>
            <a:ext cx="10350502" cy="557850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261983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 descr="A close-up of a greyscale photo of a grid&#10;&#10;Description automatically generated">
            <a:extLst>
              <a:ext uri="{FF2B5EF4-FFF2-40B4-BE49-F238E27FC236}">
                <a16:creationId xmlns:a16="http://schemas.microsoft.com/office/drawing/2014/main" id="{10AC26EA-255C-796C-BD68-C82626CE793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rcRect l="1093" t="2174" r="981" b="6461"/>
          <a:stretch/>
        </p:blipFill>
        <p:spPr>
          <a:xfrm>
            <a:off x="1492419" y="670921"/>
            <a:ext cx="10381129" cy="5884431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39" name="Group 38">
            <a:extLst>
              <a:ext uri="{FF2B5EF4-FFF2-40B4-BE49-F238E27FC236}">
                <a16:creationId xmlns:a16="http://schemas.microsoft.com/office/drawing/2014/main" id="{26E52161-C3DC-BF96-6AD6-CCCD04FAC12C}"/>
              </a:ext>
            </a:extLst>
          </p:cNvPr>
          <p:cNvGrpSpPr/>
          <p:nvPr/>
        </p:nvGrpSpPr>
        <p:grpSpPr>
          <a:xfrm>
            <a:off x="2319509" y="1009685"/>
            <a:ext cx="3612995" cy="370841"/>
            <a:chOff x="2105314" y="853068"/>
            <a:chExt cx="3612995" cy="370841"/>
          </a:xfrm>
        </p:grpSpPr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0D92A6C5-A7EF-F766-4BF4-85DE7F1A67E6}"/>
                </a:ext>
              </a:extLst>
            </p:cNvPr>
            <p:cNvCxnSpPr/>
            <p:nvPr/>
          </p:nvCxnSpPr>
          <p:spPr>
            <a:xfrm>
              <a:off x="2105314" y="1223909"/>
              <a:ext cx="361299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9E76A1CE-876B-FFF4-0A6A-8A23631FBA2D}"/>
                </a:ext>
              </a:extLst>
            </p:cNvPr>
            <p:cNvSpPr txBox="1"/>
            <p:nvPr/>
          </p:nvSpPr>
          <p:spPr>
            <a:xfrm>
              <a:off x="2105314" y="853068"/>
              <a:ext cx="36129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Fasted</a:t>
              </a:r>
            </a:p>
          </p:txBody>
        </p:sp>
      </p:grpSp>
      <p:grpSp>
        <p:nvGrpSpPr>
          <p:cNvPr id="22" name="Group 21">
            <a:extLst>
              <a:ext uri="{FF2B5EF4-FFF2-40B4-BE49-F238E27FC236}">
                <a16:creationId xmlns:a16="http://schemas.microsoft.com/office/drawing/2014/main" id="{C8154DDE-6C94-B1C7-B0FE-8BF5097C0469}"/>
              </a:ext>
            </a:extLst>
          </p:cNvPr>
          <p:cNvGrpSpPr/>
          <p:nvPr/>
        </p:nvGrpSpPr>
        <p:grpSpPr>
          <a:xfrm>
            <a:off x="6917744" y="1011194"/>
            <a:ext cx="3612994" cy="369332"/>
            <a:chOff x="6592727" y="1885435"/>
            <a:chExt cx="3646100" cy="369332"/>
          </a:xfrm>
        </p:grpSpPr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0BB49961-E24D-BCAF-B673-428585BE77FE}"/>
                </a:ext>
              </a:extLst>
            </p:cNvPr>
            <p:cNvCxnSpPr>
              <a:cxnSpLocks/>
            </p:cNvCxnSpPr>
            <p:nvPr/>
          </p:nvCxnSpPr>
          <p:spPr>
            <a:xfrm>
              <a:off x="6592727" y="2253258"/>
              <a:ext cx="361299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F0486AE8-A58B-8CC0-1EC5-8E96FA4DB46E}"/>
                </a:ext>
              </a:extLst>
            </p:cNvPr>
            <p:cNvSpPr txBox="1"/>
            <p:nvPr/>
          </p:nvSpPr>
          <p:spPr>
            <a:xfrm>
              <a:off x="6625833" y="1885435"/>
              <a:ext cx="36129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Refed</a:t>
              </a:r>
            </a:p>
          </p:txBody>
        </p:sp>
      </p:grpSp>
      <p:grpSp>
        <p:nvGrpSpPr>
          <p:cNvPr id="59" name="Group 58">
            <a:extLst>
              <a:ext uri="{FF2B5EF4-FFF2-40B4-BE49-F238E27FC236}">
                <a16:creationId xmlns:a16="http://schemas.microsoft.com/office/drawing/2014/main" id="{D4426270-B8D8-45D6-8EBB-4463B9AE23DD}"/>
              </a:ext>
            </a:extLst>
          </p:cNvPr>
          <p:cNvGrpSpPr/>
          <p:nvPr/>
        </p:nvGrpSpPr>
        <p:grpSpPr>
          <a:xfrm>
            <a:off x="8945918" y="1528257"/>
            <a:ext cx="1880761" cy="369332"/>
            <a:chOff x="4259067" y="2088861"/>
            <a:chExt cx="1661336" cy="369332"/>
          </a:xfrm>
        </p:grpSpPr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99329D17-994D-F884-E452-95D92622B260}"/>
                </a:ext>
              </a:extLst>
            </p:cNvPr>
            <p:cNvSpPr txBox="1"/>
            <p:nvPr/>
          </p:nvSpPr>
          <p:spPr>
            <a:xfrm>
              <a:off x="4259067" y="2088861"/>
              <a:ext cx="16613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L-Raptor-KO</a:t>
              </a:r>
            </a:p>
          </p:txBody>
        </p:sp>
        <p:cxnSp>
          <p:nvCxnSpPr>
            <p:cNvPr id="61" name="Straight Connector 60">
              <a:extLst>
                <a:ext uri="{FF2B5EF4-FFF2-40B4-BE49-F238E27FC236}">
                  <a16:creationId xmlns:a16="http://schemas.microsoft.com/office/drawing/2014/main" id="{8A68CAF4-BA67-8119-9AC9-BC90C7189CA2}"/>
                </a:ext>
              </a:extLst>
            </p:cNvPr>
            <p:cNvCxnSpPr>
              <a:cxnSpLocks/>
            </p:cNvCxnSpPr>
            <p:nvPr/>
          </p:nvCxnSpPr>
          <p:spPr>
            <a:xfrm>
              <a:off x="4259067" y="2458193"/>
              <a:ext cx="16613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07E0DFBD-4120-9239-5910-60ABF9AA6F83}"/>
              </a:ext>
            </a:extLst>
          </p:cNvPr>
          <p:cNvGrpSpPr/>
          <p:nvPr/>
        </p:nvGrpSpPr>
        <p:grpSpPr>
          <a:xfrm>
            <a:off x="6682984" y="1528257"/>
            <a:ext cx="1880761" cy="369332"/>
            <a:chOff x="4259067" y="2088861"/>
            <a:chExt cx="1661336" cy="369332"/>
          </a:xfrm>
        </p:grpSpPr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A2C9EBAC-F98A-CC03-2757-E5137C6DBFAF}"/>
                </a:ext>
              </a:extLst>
            </p:cNvPr>
            <p:cNvSpPr txBox="1"/>
            <p:nvPr/>
          </p:nvSpPr>
          <p:spPr>
            <a:xfrm>
              <a:off x="4259067" y="2088861"/>
              <a:ext cx="16613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31D585D7-359E-F740-7F4E-9619588B481D}"/>
                </a:ext>
              </a:extLst>
            </p:cNvPr>
            <p:cNvCxnSpPr>
              <a:cxnSpLocks/>
            </p:cNvCxnSpPr>
            <p:nvPr/>
          </p:nvCxnSpPr>
          <p:spPr>
            <a:xfrm>
              <a:off x="4259067" y="2458193"/>
              <a:ext cx="16613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D0AFA08F-802F-1A09-8A39-53023500505A}"/>
              </a:ext>
            </a:extLst>
          </p:cNvPr>
          <p:cNvGrpSpPr/>
          <p:nvPr/>
        </p:nvGrpSpPr>
        <p:grpSpPr>
          <a:xfrm>
            <a:off x="4203593" y="1533367"/>
            <a:ext cx="2011680" cy="369332"/>
            <a:chOff x="4259067" y="2088861"/>
            <a:chExt cx="1661336" cy="369332"/>
          </a:xfrm>
        </p:grpSpPr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EF0DADD5-0075-99F5-5C7A-CA046CD7D3FC}"/>
                </a:ext>
              </a:extLst>
            </p:cNvPr>
            <p:cNvSpPr txBox="1"/>
            <p:nvPr/>
          </p:nvSpPr>
          <p:spPr>
            <a:xfrm>
              <a:off x="4259067" y="2088861"/>
              <a:ext cx="16613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L-Raptor-KO</a:t>
              </a:r>
            </a:p>
          </p:txBody>
        </p: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1C91D279-92D7-2AA5-135C-4F97F0FD7F72}"/>
                </a:ext>
              </a:extLst>
            </p:cNvPr>
            <p:cNvCxnSpPr>
              <a:cxnSpLocks/>
            </p:cNvCxnSpPr>
            <p:nvPr/>
          </p:nvCxnSpPr>
          <p:spPr>
            <a:xfrm>
              <a:off x="4259067" y="2458193"/>
              <a:ext cx="16613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" name="Group 17">
            <a:extLst>
              <a:ext uri="{FF2B5EF4-FFF2-40B4-BE49-F238E27FC236}">
                <a16:creationId xmlns:a16="http://schemas.microsoft.com/office/drawing/2014/main" id="{4B038CB6-8EC8-E154-6B41-ADBF45A29F70}"/>
              </a:ext>
            </a:extLst>
          </p:cNvPr>
          <p:cNvGrpSpPr/>
          <p:nvPr/>
        </p:nvGrpSpPr>
        <p:grpSpPr>
          <a:xfrm>
            <a:off x="2027813" y="1528257"/>
            <a:ext cx="2012691" cy="369332"/>
            <a:chOff x="4259067" y="2088861"/>
            <a:chExt cx="1661336" cy="369332"/>
          </a:xfrm>
        </p:grpSpPr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87FE6A94-630C-FE23-741A-AE1454E85780}"/>
                </a:ext>
              </a:extLst>
            </p:cNvPr>
            <p:cNvSpPr txBox="1"/>
            <p:nvPr/>
          </p:nvSpPr>
          <p:spPr>
            <a:xfrm>
              <a:off x="4259067" y="2088861"/>
              <a:ext cx="16613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E9C0FE81-F752-BF54-038F-B5FDEA75752E}"/>
                </a:ext>
              </a:extLst>
            </p:cNvPr>
            <p:cNvCxnSpPr>
              <a:cxnSpLocks/>
            </p:cNvCxnSpPr>
            <p:nvPr/>
          </p:nvCxnSpPr>
          <p:spPr>
            <a:xfrm>
              <a:off x="4259067" y="2458193"/>
              <a:ext cx="16613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4" name="TextBox 43">
            <a:extLst>
              <a:ext uri="{FF2B5EF4-FFF2-40B4-BE49-F238E27FC236}">
                <a16:creationId xmlns:a16="http://schemas.microsoft.com/office/drawing/2014/main" id="{B32E393A-C212-6015-51F6-513210570149}"/>
              </a:ext>
            </a:extLst>
          </p:cNvPr>
          <p:cNvSpPr txBox="1"/>
          <p:nvPr/>
        </p:nvSpPr>
        <p:spPr>
          <a:xfrm>
            <a:off x="41302" y="3968453"/>
            <a:ext cx="1138453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p-GSK3β</a:t>
            </a:r>
          </a:p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S9)</a:t>
            </a:r>
          </a:p>
        </p:txBody>
      </p:sp>
      <p:cxnSp>
        <p:nvCxnSpPr>
          <p:cNvPr id="2" name="Straight Arrow Connector 1">
            <a:extLst>
              <a:ext uri="{FF2B5EF4-FFF2-40B4-BE49-F238E27FC236}">
                <a16:creationId xmlns:a16="http://schemas.microsoft.com/office/drawing/2014/main" id="{1B23005F-F330-F944-EA6E-2AA1F9E7E247}"/>
              </a:ext>
            </a:extLst>
          </p:cNvPr>
          <p:cNvCxnSpPr>
            <a:cxnSpLocks/>
          </p:cNvCxnSpPr>
          <p:nvPr/>
        </p:nvCxnSpPr>
        <p:spPr>
          <a:xfrm>
            <a:off x="1179755" y="4245452"/>
            <a:ext cx="645344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88CAAC76-4B64-75B6-EB0E-8DC320376E44}"/>
              </a:ext>
            </a:extLst>
          </p:cNvPr>
          <p:cNvSpPr txBox="1"/>
          <p:nvPr/>
        </p:nvSpPr>
        <p:spPr>
          <a:xfrm>
            <a:off x="10994236" y="648866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3A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C71ED5DF-7344-827C-A424-D43A3B27EDCB}"/>
              </a:ext>
            </a:extLst>
          </p:cNvPr>
          <p:cNvSpPr/>
          <p:nvPr/>
        </p:nvSpPr>
        <p:spPr>
          <a:xfrm>
            <a:off x="1825099" y="3741001"/>
            <a:ext cx="9210374" cy="78143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383473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A close-up of a black and white photo&#10;&#10;Description automatically generated">
            <a:extLst>
              <a:ext uri="{FF2B5EF4-FFF2-40B4-BE49-F238E27FC236}">
                <a16:creationId xmlns:a16="http://schemas.microsoft.com/office/drawing/2014/main" id="{8B2C1A08-43D9-04E4-8EAD-6781BE5CAB3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-127" t="804" r="1419" b="4399"/>
          <a:stretch/>
        </p:blipFill>
        <p:spPr>
          <a:xfrm>
            <a:off x="1323191" y="720765"/>
            <a:ext cx="10402643" cy="5776855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39" name="Group 38">
            <a:extLst>
              <a:ext uri="{FF2B5EF4-FFF2-40B4-BE49-F238E27FC236}">
                <a16:creationId xmlns:a16="http://schemas.microsoft.com/office/drawing/2014/main" id="{26E52161-C3DC-BF96-6AD6-CCCD04FAC12C}"/>
              </a:ext>
            </a:extLst>
          </p:cNvPr>
          <p:cNvGrpSpPr/>
          <p:nvPr/>
        </p:nvGrpSpPr>
        <p:grpSpPr>
          <a:xfrm>
            <a:off x="2319509" y="-55326"/>
            <a:ext cx="3612995" cy="370841"/>
            <a:chOff x="2105314" y="853068"/>
            <a:chExt cx="3612995" cy="370841"/>
          </a:xfrm>
        </p:grpSpPr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0D92A6C5-A7EF-F766-4BF4-85DE7F1A67E6}"/>
                </a:ext>
              </a:extLst>
            </p:cNvPr>
            <p:cNvCxnSpPr/>
            <p:nvPr/>
          </p:nvCxnSpPr>
          <p:spPr>
            <a:xfrm>
              <a:off x="2105314" y="1223909"/>
              <a:ext cx="361299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9E76A1CE-876B-FFF4-0A6A-8A23631FBA2D}"/>
                </a:ext>
              </a:extLst>
            </p:cNvPr>
            <p:cNvSpPr txBox="1"/>
            <p:nvPr/>
          </p:nvSpPr>
          <p:spPr>
            <a:xfrm>
              <a:off x="2105314" y="853068"/>
              <a:ext cx="36129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Fasted</a:t>
              </a:r>
            </a:p>
          </p:txBody>
        </p:sp>
      </p:grpSp>
      <p:grpSp>
        <p:nvGrpSpPr>
          <p:cNvPr id="22" name="Group 21">
            <a:extLst>
              <a:ext uri="{FF2B5EF4-FFF2-40B4-BE49-F238E27FC236}">
                <a16:creationId xmlns:a16="http://schemas.microsoft.com/office/drawing/2014/main" id="{C8154DDE-6C94-B1C7-B0FE-8BF5097C0469}"/>
              </a:ext>
            </a:extLst>
          </p:cNvPr>
          <p:cNvGrpSpPr/>
          <p:nvPr/>
        </p:nvGrpSpPr>
        <p:grpSpPr>
          <a:xfrm>
            <a:off x="6917744" y="-53817"/>
            <a:ext cx="3612994" cy="369332"/>
            <a:chOff x="6592727" y="1885435"/>
            <a:chExt cx="3646100" cy="369332"/>
          </a:xfrm>
        </p:grpSpPr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0BB49961-E24D-BCAF-B673-428585BE77FE}"/>
                </a:ext>
              </a:extLst>
            </p:cNvPr>
            <p:cNvCxnSpPr>
              <a:cxnSpLocks/>
            </p:cNvCxnSpPr>
            <p:nvPr/>
          </p:nvCxnSpPr>
          <p:spPr>
            <a:xfrm>
              <a:off x="6592727" y="2253258"/>
              <a:ext cx="361299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F0486AE8-A58B-8CC0-1EC5-8E96FA4DB46E}"/>
                </a:ext>
              </a:extLst>
            </p:cNvPr>
            <p:cNvSpPr txBox="1"/>
            <p:nvPr/>
          </p:nvSpPr>
          <p:spPr>
            <a:xfrm>
              <a:off x="6625833" y="1885435"/>
              <a:ext cx="36129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Refed</a:t>
              </a:r>
            </a:p>
          </p:txBody>
        </p:sp>
      </p:grpSp>
      <p:grpSp>
        <p:nvGrpSpPr>
          <p:cNvPr id="59" name="Group 58">
            <a:extLst>
              <a:ext uri="{FF2B5EF4-FFF2-40B4-BE49-F238E27FC236}">
                <a16:creationId xmlns:a16="http://schemas.microsoft.com/office/drawing/2014/main" id="{D4426270-B8D8-45D6-8EBB-4463B9AE23DD}"/>
              </a:ext>
            </a:extLst>
          </p:cNvPr>
          <p:cNvGrpSpPr/>
          <p:nvPr/>
        </p:nvGrpSpPr>
        <p:grpSpPr>
          <a:xfrm>
            <a:off x="8945918" y="301880"/>
            <a:ext cx="1880761" cy="369332"/>
            <a:chOff x="4259067" y="2088861"/>
            <a:chExt cx="1661336" cy="369332"/>
          </a:xfrm>
        </p:grpSpPr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99329D17-994D-F884-E452-95D92622B260}"/>
                </a:ext>
              </a:extLst>
            </p:cNvPr>
            <p:cNvSpPr txBox="1"/>
            <p:nvPr/>
          </p:nvSpPr>
          <p:spPr>
            <a:xfrm>
              <a:off x="4259067" y="2088861"/>
              <a:ext cx="16613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L-Raptor-KO</a:t>
              </a:r>
            </a:p>
          </p:txBody>
        </p:sp>
        <p:cxnSp>
          <p:nvCxnSpPr>
            <p:cNvPr id="61" name="Straight Connector 60">
              <a:extLst>
                <a:ext uri="{FF2B5EF4-FFF2-40B4-BE49-F238E27FC236}">
                  <a16:creationId xmlns:a16="http://schemas.microsoft.com/office/drawing/2014/main" id="{8A68CAF4-BA67-8119-9AC9-BC90C7189CA2}"/>
                </a:ext>
              </a:extLst>
            </p:cNvPr>
            <p:cNvCxnSpPr>
              <a:cxnSpLocks/>
            </p:cNvCxnSpPr>
            <p:nvPr/>
          </p:nvCxnSpPr>
          <p:spPr>
            <a:xfrm>
              <a:off x="4259067" y="2458193"/>
              <a:ext cx="16613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07E0DFBD-4120-9239-5910-60ABF9AA6F83}"/>
              </a:ext>
            </a:extLst>
          </p:cNvPr>
          <p:cNvGrpSpPr/>
          <p:nvPr/>
        </p:nvGrpSpPr>
        <p:grpSpPr>
          <a:xfrm>
            <a:off x="6682984" y="301880"/>
            <a:ext cx="1880761" cy="369332"/>
            <a:chOff x="4259067" y="2088861"/>
            <a:chExt cx="1661336" cy="369332"/>
          </a:xfrm>
        </p:grpSpPr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A2C9EBAC-F98A-CC03-2757-E5137C6DBFAF}"/>
                </a:ext>
              </a:extLst>
            </p:cNvPr>
            <p:cNvSpPr txBox="1"/>
            <p:nvPr/>
          </p:nvSpPr>
          <p:spPr>
            <a:xfrm>
              <a:off x="4259067" y="2088861"/>
              <a:ext cx="16613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31D585D7-359E-F740-7F4E-9619588B481D}"/>
                </a:ext>
              </a:extLst>
            </p:cNvPr>
            <p:cNvCxnSpPr>
              <a:cxnSpLocks/>
            </p:cNvCxnSpPr>
            <p:nvPr/>
          </p:nvCxnSpPr>
          <p:spPr>
            <a:xfrm>
              <a:off x="4259067" y="2458193"/>
              <a:ext cx="16613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D0AFA08F-802F-1A09-8A39-53023500505A}"/>
              </a:ext>
            </a:extLst>
          </p:cNvPr>
          <p:cNvGrpSpPr/>
          <p:nvPr/>
        </p:nvGrpSpPr>
        <p:grpSpPr>
          <a:xfrm>
            <a:off x="4203593" y="306990"/>
            <a:ext cx="2011680" cy="369332"/>
            <a:chOff x="4259067" y="2088861"/>
            <a:chExt cx="1661336" cy="369332"/>
          </a:xfrm>
        </p:grpSpPr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EF0DADD5-0075-99F5-5C7A-CA046CD7D3FC}"/>
                </a:ext>
              </a:extLst>
            </p:cNvPr>
            <p:cNvSpPr txBox="1"/>
            <p:nvPr/>
          </p:nvSpPr>
          <p:spPr>
            <a:xfrm>
              <a:off x="4259067" y="2088861"/>
              <a:ext cx="16613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L-Raptor-KO</a:t>
              </a:r>
            </a:p>
          </p:txBody>
        </p: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1C91D279-92D7-2AA5-135C-4F97F0FD7F72}"/>
                </a:ext>
              </a:extLst>
            </p:cNvPr>
            <p:cNvCxnSpPr>
              <a:cxnSpLocks/>
            </p:cNvCxnSpPr>
            <p:nvPr/>
          </p:nvCxnSpPr>
          <p:spPr>
            <a:xfrm>
              <a:off x="4259067" y="2458193"/>
              <a:ext cx="16613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" name="Group 17">
            <a:extLst>
              <a:ext uri="{FF2B5EF4-FFF2-40B4-BE49-F238E27FC236}">
                <a16:creationId xmlns:a16="http://schemas.microsoft.com/office/drawing/2014/main" id="{4B038CB6-8EC8-E154-6B41-ADBF45A29F70}"/>
              </a:ext>
            </a:extLst>
          </p:cNvPr>
          <p:cNvGrpSpPr/>
          <p:nvPr/>
        </p:nvGrpSpPr>
        <p:grpSpPr>
          <a:xfrm>
            <a:off x="2027813" y="301880"/>
            <a:ext cx="2012691" cy="369332"/>
            <a:chOff x="4259067" y="2088861"/>
            <a:chExt cx="1661336" cy="369332"/>
          </a:xfrm>
        </p:grpSpPr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87FE6A94-630C-FE23-741A-AE1454E85780}"/>
                </a:ext>
              </a:extLst>
            </p:cNvPr>
            <p:cNvSpPr txBox="1"/>
            <p:nvPr/>
          </p:nvSpPr>
          <p:spPr>
            <a:xfrm>
              <a:off x="4259067" y="2088861"/>
              <a:ext cx="16613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E9C0FE81-F752-BF54-038F-B5FDEA75752E}"/>
                </a:ext>
              </a:extLst>
            </p:cNvPr>
            <p:cNvCxnSpPr>
              <a:cxnSpLocks/>
            </p:cNvCxnSpPr>
            <p:nvPr/>
          </p:nvCxnSpPr>
          <p:spPr>
            <a:xfrm>
              <a:off x="4259067" y="2458193"/>
              <a:ext cx="16613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0" name="TextBox 29">
            <a:extLst>
              <a:ext uri="{FF2B5EF4-FFF2-40B4-BE49-F238E27FC236}">
                <a16:creationId xmlns:a16="http://schemas.microsoft.com/office/drawing/2014/main" id="{44B716B8-2AC8-0DC2-CAD5-16E097CA738E}"/>
              </a:ext>
            </a:extLst>
          </p:cNvPr>
          <p:cNvSpPr txBox="1"/>
          <p:nvPr/>
        </p:nvSpPr>
        <p:spPr>
          <a:xfrm>
            <a:off x="213663" y="4240316"/>
            <a:ext cx="942886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p-S6</a:t>
            </a:r>
          </a:p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S240/244)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141A44A0-1028-43A0-31AF-508A0365573B}"/>
              </a:ext>
            </a:extLst>
          </p:cNvPr>
          <p:cNvSpPr txBox="1"/>
          <p:nvPr/>
        </p:nvSpPr>
        <p:spPr>
          <a:xfrm>
            <a:off x="265761" y="3152001"/>
            <a:ext cx="838691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p-AKT</a:t>
            </a:r>
          </a:p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S473)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7E7CA19-2168-CABB-6423-3CA08DB8439F}"/>
              </a:ext>
            </a:extLst>
          </p:cNvPr>
          <p:cNvSpPr txBox="1"/>
          <p:nvPr/>
        </p:nvSpPr>
        <p:spPr>
          <a:xfrm>
            <a:off x="10994236" y="648866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3A</a:t>
            </a:r>
          </a:p>
        </p:txBody>
      </p:sp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F828E4AF-7D14-97C9-ABC7-809F21837476}"/>
              </a:ext>
            </a:extLst>
          </p:cNvPr>
          <p:cNvCxnSpPr>
            <a:cxnSpLocks/>
          </p:cNvCxnSpPr>
          <p:nvPr/>
        </p:nvCxnSpPr>
        <p:spPr>
          <a:xfrm>
            <a:off x="1104452" y="3429000"/>
            <a:ext cx="645344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4BB2CDC2-BD5D-9373-8275-836AE5C176FE}"/>
              </a:ext>
            </a:extLst>
          </p:cNvPr>
          <p:cNvCxnSpPr>
            <a:cxnSpLocks/>
          </p:cNvCxnSpPr>
          <p:nvPr/>
        </p:nvCxnSpPr>
        <p:spPr>
          <a:xfrm>
            <a:off x="1138518" y="4517315"/>
            <a:ext cx="645344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Rectangle 12">
            <a:extLst>
              <a:ext uri="{FF2B5EF4-FFF2-40B4-BE49-F238E27FC236}">
                <a16:creationId xmlns:a16="http://schemas.microsoft.com/office/drawing/2014/main" id="{13DDA7A2-B8BA-259D-AF80-4B427FB7F79E}"/>
              </a:ext>
            </a:extLst>
          </p:cNvPr>
          <p:cNvSpPr/>
          <p:nvPr/>
        </p:nvSpPr>
        <p:spPr>
          <a:xfrm>
            <a:off x="1783862" y="3236980"/>
            <a:ext cx="9210374" cy="61656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C7627209-CE63-59DE-9FCC-8B30B5A2FC64}"/>
              </a:ext>
            </a:extLst>
          </p:cNvPr>
          <p:cNvSpPr/>
          <p:nvPr/>
        </p:nvSpPr>
        <p:spPr>
          <a:xfrm>
            <a:off x="1843108" y="4246260"/>
            <a:ext cx="9210374" cy="61656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64072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287</TotalTime>
  <Words>259</Words>
  <Application>Microsoft Macintosh PowerPoint</Application>
  <PresentationFormat>Widescreen</PresentationFormat>
  <Paragraphs>157</Paragraphs>
  <Slides>17</Slides>
  <Notes>17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7</vt:i4>
      </vt:variant>
    </vt:vector>
  </HeadingPairs>
  <TitlesOfParts>
    <vt:vector size="21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hea Uehara</dc:creator>
  <cp:lastModifiedBy>Kahea Uehara</cp:lastModifiedBy>
  <cp:revision>52</cp:revision>
  <cp:lastPrinted>2023-03-17T16:59:23Z</cp:lastPrinted>
  <dcterms:created xsi:type="dcterms:W3CDTF">2023-03-17T16:30:51Z</dcterms:created>
  <dcterms:modified xsi:type="dcterms:W3CDTF">2023-12-18T15:39:10Z</dcterms:modified>
</cp:coreProperties>
</file>